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68" r:id="rId4"/>
    <p:sldId id="256" r:id="rId5"/>
    <p:sldId id="266" r:id="rId6"/>
    <p:sldId id="26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01_Analysis\27.NIAB\2.Cucumber_2018\&#45436;&#47928;&#54868;\sequencing_statistic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01_Analysis\27.NIAB\2.Cucumber_2018\&#45436;&#47928;&#54868;\sequencing_statistic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i="1" dirty="0"/>
              <a:t>Cucumis</a:t>
            </a:r>
            <a:r>
              <a:rPr lang="en-US" altLang="ko-KR" i="1" baseline="0" dirty="0"/>
              <a:t> sativus JEF</a:t>
            </a:r>
            <a:endParaRPr lang="ko-KR" altLang="en-US" i="1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JEF!$G$2</c:f>
              <c:strCache>
                <c:ptCount val="1"/>
                <c:pt idx="0">
                  <c:v> Mapped 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JEF!$F$3:$F$29</c:f>
              <c:strCache>
                <c:ptCount val="27"/>
                <c:pt idx="0">
                  <c:v>J1_1</c:v>
                </c:pt>
                <c:pt idx="1">
                  <c:v>J1_2</c:v>
                </c:pt>
                <c:pt idx="2">
                  <c:v>J1_3</c:v>
                </c:pt>
                <c:pt idx="3">
                  <c:v>J2_1</c:v>
                </c:pt>
                <c:pt idx="4">
                  <c:v>J2_2</c:v>
                </c:pt>
                <c:pt idx="5">
                  <c:v>J2_3</c:v>
                </c:pt>
                <c:pt idx="6">
                  <c:v>J3_1</c:v>
                </c:pt>
                <c:pt idx="7">
                  <c:v>J3_2</c:v>
                </c:pt>
                <c:pt idx="8">
                  <c:v>J3_3</c:v>
                </c:pt>
                <c:pt idx="9">
                  <c:v>J4_1</c:v>
                </c:pt>
                <c:pt idx="10">
                  <c:v>J4_2</c:v>
                </c:pt>
                <c:pt idx="11">
                  <c:v>J4_3</c:v>
                </c:pt>
                <c:pt idx="12">
                  <c:v>J5_1</c:v>
                </c:pt>
                <c:pt idx="13">
                  <c:v>J5_2</c:v>
                </c:pt>
                <c:pt idx="14">
                  <c:v>J5_3</c:v>
                </c:pt>
                <c:pt idx="15">
                  <c:v>J6_1</c:v>
                </c:pt>
                <c:pt idx="16">
                  <c:v>J6_2</c:v>
                </c:pt>
                <c:pt idx="17">
                  <c:v>J6_3</c:v>
                </c:pt>
                <c:pt idx="18">
                  <c:v>J7_1</c:v>
                </c:pt>
                <c:pt idx="19">
                  <c:v>J7_2</c:v>
                </c:pt>
                <c:pt idx="20">
                  <c:v>J7_3</c:v>
                </c:pt>
                <c:pt idx="21">
                  <c:v>J8_1</c:v>
                </c:pt>
                <c:pt idx="22">
                  <c:v>J8_2</c:v>
                </c:pt>
                <c:pt idx="23">
                  <c:v>J8_3</c:v>
                </c:pt>
                <c:pt idx="24">
                  <c:v>J9_1</c:v>
                </c:pt>
                <c:pt idx="25">
                  <c:v>J9_2</c:v>
                </c:pt>
                <c:pt idx="26">
                  <c:v>WGS</c:v>
                </c:pt>
              </c:strCache>
            </c:strRef>
          </c:cat>
          <c:val>
            <c:numRef>
              <c:f>JEF!$G$3:$G$29</c:f>
              <c:numCache>
                <c:formatCode>_(* #,##0_);_(* \(#,##0\);_(* "-"_);_(@_)</c:formatCode>
                <c:ptCount val="27"/>
                <c:pt idx="0">
                  <c:v>61876192</c:v>
                </c:pt>
                <c:pt idx="1">
                  <c:v>51568030</c:v>
                </c:pt>
                <c:pt idx="2">
                  <c:v>63246960</c:v>
                </c:pt>
                <c:pt idx="3">
                  <c:v>52076370</c:v>
                </c:pt>
                <c:pt idx="4">
                  <c:v>62442896</c:v>
                </c:pt>
                <c:pt idx="5">
                  <c:v>77400480</c:v>
                </c:pt>
                <c:pt idx="6">
                  <c:v>52812518</c:v>
                </c:pt>
                <c:pt idx="7">
                  <c:v>68701732</c:v>
                </c:pt>
                <c:pt idx="8">
                  <c:v>57855306</c:v>
                </c:pt>
                <c:pt idx="9">
                  <c:v>63994440</c:v>
                </c:pt>
                <c:pt idx="10">
                  <c:v>58306830</c:v>
                </c:pt>
                <c:pt idx="11">
                  <c:v>76720528</c:v>
                </c:pt>
                <c:pt idx="12">
                  <c:v>63810390</c:v>
                </c:pt>
                <c:pt idx="13">
                  <c:v>54769108</c:v>
                </c:pt>
                <c:pt idx="14">
                  <c:v>69681582</c:v>
                </c:pt>
                <c:pt idx="15">
                  <c:v>54283086</c:v>
                </c:pt>
                <c:pt idx="16">
                  <c:v>58653398</c:v>
                </c:pt>
                <c:pt idx="17">
                  <c:v>66425722</c:v>
                </c:pt>
                <c:pt idx="18">
                  <c:v>50551182</c:v>
                </c:pt>
                <c:pt idx="19">
                  <c:v>54806188</c:v>
                </c:pt>
                <c:pt idx="20">
                  <c:v>59990846</c:v>
                </c:pt>
                <c:pt idx="21">
                  <c:v>47965394</c:v>
                </c:pt>
                <c:pt idx="22">
                  <c:v>55297100</c:v>
                </c:pt>
                <c:pt idx="23">
                  <c:v>76330692</c:v>
                </c:pt>
                <c:pt idx="24">
                  <c:v>59264178</c:v>
                </c:pt>
                <c:pt idx="25">
                  <c:v>48328022</c:v>
                </c:pt>
                <c:pt idx="26" formatCode="General">
                  <c:v>4633624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457-4ABD-B2B5-8BFCC68149DC}"/>
            </c:ext>
          </c:extLst>
        </c:ser>
        <c:ser>
          <c:idx val="1"/>
          <c:order val="1"/>
          <c:tx>
            <c:strRef>
              <c:f>JEF!$H$2</c:f>
              <c:strCache>
                <c:ptCount val="1"/>
                <c:pt idx="0">
                  <c:v> Unmapped 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JEF!$F$3:$F$29</c:f>
              <c:strCache>
                <c:ptCount val="27"/>
                <c:pt idx="0">
                  <c:v>J1_1</c:v>
                </c:pt>
                <c:pt idx="1">
                  <c:v>J1_2</c:v>
                </c:pt>
                <c:pt idx="2">
                  <c:v>J1_3</c:v>
                </c:pt>
                <c:pt idx="3">
                  <c:v>J2_1</c:v>
                </c:pt>
                <c:pt idx="4">
                  <c:v>J2_2</c:v>
                </c:pt>
                <c:pt idx="5">
                  <c:v>J2_3</c:v>
                </c:pt>
                <c:pt idx="6">
                  <c:v>J3_1</c:v>
                </c:pt>
                <c:pt idx="7">
                  <c:v>J3_2</c:v>
                </c:pt>
                <c:pt idx="8">
                  <c:v>J3_3</c:v>
                </c:pt>
                <c:pt idx="9">
                  <c:v>J4_1</c:v>
                </c:pt>
                <c:pt idx="10">
                  <c:v>J4_2</c:v>
                </c:pt>
                <c:pt idx="11">
                  <c:v>J4_3</c:v>
                </c:pt>
                <c:pt idx="12">
                  <c:v>J5_1</c:v>
                </c:pt>
                <c:pt idx="13">
                  <c:v>J5_2</c:v>
                </c:pt>
                <c:pt idx="14">
                  <c:v>J5_3</c:v>
                </c:pt>
                <c:pt idx="15">
                  <c:v>J6_1</c:v>
                </c:pt>
                <c:pt idx="16">
                  <c:v>J6_2</c:v>
                </c:pt>
                <c:pt idx="17">
                  <c:v>J6_3</c:v>
                </c:pt>
                <c:pt idx="18">
                  <c:v>J7_1</c:v>
                </c:pt>
                <c:pt idx="19">
                  <c:v>J7_2</c:v>
                </c:pt>
                <c:pt idx="20">
                  <c:v>J7_3</c:v>
                </c:pt>
                <c:pt idx="21">
                  <c:v>J8_1</c:v>
                </c:pt>
                <c:pt idx="22">
                  <c:v>J8_2</c:v>
                </c:pt>
                <c:pt idx="23">
                  <c:v>J8_3</c:v>
                </c:pt>
                <c:pt idx="24">
                  <c:v>J9_1</c:v>
                </c:pt>
                <c:pt idx="25">
                  <c:v>J9_2</c:v>
                </c:pt>
                <c:pt idx="26">
                  <c:v>WGS</c:v>
                </c:pt>
              </c:strCache>
            </c:strRef>
          </c:cat>
          <c:val>
            <c:numRef>
              <c:f>JEF!$H$3:$H$29</c:f>
              <c:numCache>
                <c:formatCode>_(* #,##0_);_(* \(#,##0\);_(* "-"_);_(@_)</c:formatCode>
                <c:ptCount val="27"/>
                <c:pt idx="0">
                  <c:v>1407292</c:v>
                </c:pt>
                <c:pt idx="1">
                  <c:v>1259639</c:v>
                </c:pt>
                <c:pt idx="2">
                  <c:v>1509897</c:v>
                </c:pt>
                <c:pt idx="3">
                  <c:v>1111398</c:v>
                </c:pt>
                <c:pt idx="4">
                  <c:v>1660156</c:v>
                </c:pt>
                <c:pt idx="5">
                  <c:v>1776728</c:v>
                </c:pt>
                <c:pt idx="6">
                  <c:v>1373535</c:v>
                </c:pt>
                <c:pt idx="7">
                  <c:v>1640401</c:v>
                </c:pt>
                <c:pt idx="8">
                  <c:v>1564104</c:v>
                </c:pt>
                <c:pt idx="9">
                  <c:v>1828427</c:v>
                </c:pt>
                <c:pt idx="10">
                  <c:v>1474026</c:v>
                </c:pt>
                <c:pt idx="11">
                  <c:v>1720384</c:v>
                </c:pt>
                <c:pt idx="12">
                  <c:v>1794849</c:v>
                </c:pt>
                <c:pt idx="13">
                  <c:v>1524190</c:v>
                </c:pt>
                <c:pt idx="14">
                  <c:v>1667887</c:v>
                </c:pt>
                <c:pt idx="15">
                  <c:v>1582671</c:v>
                </c:pt>
                <c:pt idx="16">
                  <c:v>1403719</c:v>
                </c:pt>
                <c:pt idx="17">
                  <c:v>1953393</c:v>
                </c:pt>
                <c:pt idx="18">
                  <c:v>1771328</c:v>
                </c:pt>
                <c:pt idx="19">
                  <c:v>2297540</c:v>
                </c:pt>
                <c:pt idx="20">
                  <c:v>2343530</c:v>
                </c:pt>
                <c:pt idx="21">
                  <c:v>1757875</c:v>
                </c:pt>
                <c:pt idx="22">
                  <c:v>1396908</c:v>
                </c:pt>
                <c:pt idx="23">
                  <c:v>2004856</c:v>
                </c:pt>
                <c:pt idx="24">
                  <c:v>4231124</c:v>
                </c:pt>
                <c:pt idx="25">
                  <c:v>2914921</c:v>
                </c:pt>
                <c:pt idx="26" formatCode="General">
                  <c:v>168573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457-4ABD-B2B5-8BFCC68149DC}"/>
            </c:ext>
          </c:extLst>
        </c:ser>
        <c:ser>
          <c:idx val="2"/>
          <c:order val="2"/>
          <c:tx>
            <c:strRef>
              <c:f>JEF!$I$2</c:f>
              <c:strCache>
                <c:ptCount val="1"/>
                <c:pt idx="0">
                  <c:v> Contaminants 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JEF!$F$3:$F$29</c:f>
              <c:strCache>
                <c:ptCount val="27"/>
                <c:pt idx="0">
                  <c:v>J1_1</c:v>
                </c:pt>
                <c:pt idx="1">
                  <c:v>J1_2</c:v>
                </c:pt>
                <c:pt idx="2">
                  <c:v>J1_3</c:v>
                </c:pt>
                <c:pt idx="3">
                  <c:v>J2_1</c:v>
                </c:pt>
                <c:pt idx="4">
                  <c:v>J2_2</c:v>
                </c:pt>
                <c:pt idx="5">
                  <c:v>J2_3</c:v>
                </c:pt>
                <c:pt idx="6">
                  <c:v>J3_1</c:v>
                </c:pt>
                <c:pt idx="7">
                  <c:v>J3_2</c:v>
                </c:pt>
                <c:pt idx="8">
                  <c:v>J3_3</c:v>
                </c:pt>
                <c:pt idx="9">
                  <c:v>J4_1</c:v>
                </c:pt>
                <c:pt idx="10">
                  <c:v>J4_2</c:v>
                </c:pt>
                <c:pt idx="11">
                  <c:v>J4_3</c:v>
                </c:pt>
                <c:pt idx="12">
                  <c:v>J5_1</c:v>
                </c:pt>
                <c:pt idx="13">
                  <c:v>J5_2</c:v>
                </c:pt>
                <c:pt idx="14">
                  <c:v>J5_3</c:v>
                </c:pt>
                <c:pt idx="15">
                  <c:v>J6_1</c:v>
                </c:pt>
                <c:pt idx="16">
                  <c:v>J6_2</c:v>
                </c:pt>
                <c:pt idx="17">
                  <c:v>J6_3</c:v>
                </c:pt>
                <c:pt idx="18">
                  <c:v>J7_1</c:v>
                </c:pt>
                <c:pt idx="19">
                  <c:v>J7_2</c:v>
                </c:pt>
                <c:pt idx="20">
                  <c:v>J7_3</c:v>
                </c:pt>
                <c:pt idx="21">
                  <c:v>J8_1</c:v>
                </c:pt>
                <c:pt idx="22">
                  <c:v>J8_2</c:v>
                </c:pt>
                <c:pt idx="23">
                  <c:v>J8_3</c:v>
                </c:pt>
                <c:pt idx="24">
                  <c:v>J9_1</c:v>
                </c:pt>
                <c:pt idx="25">
                  <c:v>J9_2</c:v>
                </c:pt>
                <c:pt idx="26">
                  <c:v>WGS</c:v>
                </c:pt>
              </c:strCache>
            </c:strRef>
          </c:cat>
          <c:val>
            <c:numRef>
              <c:f>JEF!$I$3:$I$29</c:f>
              <c:numCache>
                <c:formatCode>General</c:formatCode>
                <c:ptCount val="27"/>
                <c:pt idx="26" formatCode="#,##0">
                  <c:v>1953478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457-4ABD-B2B5-8BFCC68149DC}"/>
            </c:ext>
          </c:extLst>
        </c:ser>
        <c:ser>
          <c:idx val="3"/>
          <c:order val="3"/>
          <c:tx>
            <c:strRef>
              <c:f>JEF!$J$2</c:f>
              <c:strCache>
                <c:ptCount val="1"/>
                <c:pt idx="0">
                  <c:v> Low quality 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JEF!$F$3:$F$29</c:f>
              <c:strCache>
                <c:ptCount val="27"/>
                <c:pt idx="0">
                  <c:v>J1_1</c:v>
                </c:pt>
                <c:pt idx="1">
                  <c:v>J1_2</c:v>
                </c:pt>
                <c:pt idx="2">
                  <c:v>J1_3</c:v>
                </c:pt>
                <c:pt idx="3">
                  <c:v>J2_1</c:v>
                </c:pt>
                <c:pt idx="4">
                  <c:v>J2_2</c:v>
                </c:pt>
                <c:pt idx="5">
                  <c:v>J2_3</c:v>
                </c:pt>
                <c:pt idx="6">
                  <c:v>J3_1</c:v>
                </c:pt>
                <c:pt idx="7">
                  <c:v>J3_2</c:v>
                </c:pt>
                <c:pt idx="8">
                  <c:v>J3_3</c:v>
                </c:pt>
                <c:pt idx="9">
                  <c:v>J4_1</c:v>
                </c:pt>
                <c:pt idx="10">
                  <c:v>J4_2</c:v>
                </c:pt>
                <c:pt idx="11">
                  <c:v>J4_3</c:v>
                </c:pt>
                <c:pt idx="12">
                  <c:v>J5_1</c:v>
                </c:pt>
                <c:pt idx="13">
                  <c:v>J5_2</c:v>
                </c:pt>
                <c:pt idx="14">
                  <c:v>J5_3</c:v>
                </c:pt>
                <c:pt idx="15">
                  <c:v>J6_1</c:v>
                </c:pt>
                <c:pt idx="16">
                  <c:v>J6_2</c:v>
                </c:pt>
                <c:pt idx="17">
                  <c:v>J6_3</c:v>
                </c:pt>
                <c:pt idx="18">
                  <c:v>J7_1</c:v>
                </c:pt>
                <c:pt idx="19">
                  <c:v>J7_2</c:v>
                </c:pt>
                <c:pt idx="20">
                  <c:v>J7_3</c:v>
                </c:pt>
                <c:pt idx="21">
                  <c:v>J8_1</c:v>
                </c:pt>
                <c:pt idx="22">
                  <c:v>J8_2</c:v>
                </c:pt>
                <c:pt idx="23">
                  <c:v>J8_3</c:v>
                </c:pt>
                <c:pt idx="24">
                  <c:v>J9_1</c:v>
                </c:pt>
                <c:pt idx="25">
                  <c:v>J9_2</c:v>
                </c:pt>
                <c:pt idx="26">
                  <c:v>WGS</c:v>
                </c:pt>
              </c:strCache>
            </c:strRef>
          </c:cat>
          <c:val>
            <c:numRef>
              <c:f>JEF!$J$3:$J$29</c:f>
              <c:numCache>
                <c:formatCode>_(* #,##0_);_(* \(#,##0\);_(* "-"_);_(@_)</c:formatCode>
                <c:ptCount val="27"/>
                <c:pt idx="0">
                  <c:v>642260</c:v>
                </c:pt>
                <c:pt idx="1">
                  <c:v>530579</c:v>
                </c:pt>
                <c:pt idx="2">
                  <c:v>698789</c:v>
                </c:pt>
                <c:pt idx="3">
                  <c:v>507848</c:v>
                </c:pt>
                <c:pt idx="4">
                  <c:v>628980</c:v>
                </c:pt>
                <c:pt idx="5">
                  <c:v>807970</c:v>
                </c:pt>
                <c:pt idx="6">
                  <c:v>550275</c:v>
                </c:pt>
                <c:pt idx="7">
                  <c:v>733943</c:v>
                </c:pt>
                <c:pt idx="8">
                  <c:v>566964</c:v>
                </c:pt>
                <c:pt idx="9">
                  <c:v>631049</c:v>
                </c:pt>
                <c:pt idx="10">
                  <c:v>557020</c:v>
                </c:pt>
                <c:pt idx="11">
                  <c:v>699708</c:v>
                </c:pt>
                <c:pt idx="12">
                  <c:v>689311</c:v>
                </c:pt>
                <c:pt idx="13">
                  <c:v>611430</c:v>
                </c:pt>
                <c:pt idx="14">
                  <c:v>690415</c:v>
                </c:pt>
                <c:pt idx="15">
                  <c:v>621789</c:v>
                </c:pt>
                <c:pt idx="16">
                  <c:v>546275</c:v>
                </c:pt>
                <c:pt idx="17">
                  <c:v>730939</c:v>
                </c:pt>
                <c:pt idx="18">
                  <c:v>556596</c:v>
                </c:pt>
                <c:pt idx="19">
                  <c:v>573296</c:v>
                </c:pt>
                <c:pt idx="20">
                  <c:v>706932</c:v>
                </c:pt>
                <c:pt idx="21">
                  <c:v>514093</c:v>
                </c:pt>
                <c:pt idx="22">
                  <c:v>573034</c:v>
                </c:pt>
                <c:pt idx="23">
                  <c:v>741942</c:v>
                </c:pt>
                <c:pt idx="24">
                  <c:v>573596</c:v>
                </c:pt>
                <c:pt idx="25">
                  <c:v>477421</c:v>
                </c:pt>
                <c:pt idx="26" formatCode="#,##0">
                  <c:v>443503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457-4ABD-B2B5-8BFCC68149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73646863"/>
        <c:axId val="273624815"/>
      </c:barChart>
      <c:catAx>
        <c:axId val="2736468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624815"/>
        <c:crosses val="autoZero"/>
        <c:auto val="1"/>
        <c:lblAlgn val="ctr"/>
        <c:lblOffset val="100"/>
        <c:noMultiLvlLbl val="0"/>
      </c:catAx>
      <c:valAx>
        <c:axId val="27362481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64686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i="1" dirty="0"/>
              <a:t>Cucumis sativus KWS</a:t>
            </a:r>
            <a:endParaRPr lang="ko-KR" altLang="en-US" i="1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KWS!$G$2</c:f>
              <c:strCache>
                <c:ptCount val="1"/>
                <c:pt idx="0">
                  <c:v> Mapped 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KWS!$F$3:$F$30</c:f>
              <c:strCache>
                <c:ptCount val="28"/>
                <c:pt idx="0">
                  <c:v>K1_1</c:v>
                </c:pt>
                <c:pt idx="1">
                  <c:v>K1_2</c:v>
                </c:pt>
                <c:pt idx="2">
                  <c:v>K1_3</c:v>
                </c:pt>
                <c:pt idx="3">
                  <c:v>K2_1</c:v>
                </c:pt>
                <c:pt idx="4">
                  <c:v>K2_2</c:v>
                </c:pt>
                <c:pt idx="5">
                  <c:v>K2_3</c:v>
                </c:pt>
                <c:pt idx="6">
                  <c:v>K3_1</c:v>
                </c:pt>
                <c:pt idx="7">
                  <c:v>K3_2</c:v>
                </c:pt>
                <c:pt idx="8">
                  <c:v>K3_3</c:v>
                </c:pt>
                <c:pt idx="9">
                  <c:v>K4_1</c:v>
                </c:pt>
                <c:pt idx="10">
                  <c:v>K4_2</c:v>
                </c:pt>
                <c:pt idx="11">
                  <c:v>K4_3</c:v>
                </c:pt>
                <c:pt idx="12">
                  <c:v>K5_1</c:v>
                </c:pt>
                <c:pt idx="13">
                  <c:v>K5_2</c:v>
                </c:pt>
                <c:pt idx="14">
                  <c:v>K5_3</c:v>
                </c:pt>
                <c:pt idx="15">
                  <c:v>K6_1</c:v>
                </c:pt>
                <c:pt idx="16">
                  <c:v>K6_2</c:v>
                </c:pt>
                <c:pt idx="17">
                  <c:v>K6_3</c:v>
                </c:pt>
                <c:pt idx="18">
                  <c:v>K7_1</c:v>
                </c:pt>
                <c:pt idx="19">
                  <c:v>K7_2</c:v>
                </c:pt>
                <c:pt idx="20">
                  <c:v>K7_3</c:v>
                </c:pt>
                <c:pt idx="21">
                  <c:v>K8_1</c:v>
                </c:pt>
                <c:pt idx="22">
                  <c:v>K8_2</c:v>
                </c:pt>
                <c:pt idx="23">
                  <c:v>K8_3</c:v>
                </c:pt>
                <c:pt idx="24">
                  <c:v>K9_1</c:v>
                </c:pt>
                <c:pt idx="25">
                  <c:v>K9_2</c:v>
                </c:pt>
                <c:pt idx="26">
                  <c:v>K9_3</c:v>
                </c:pt>
                <c:pt idx="27">
                  <c:v>WGS</c:v>
                </c:pt>
              </c:strCache>
            </c:strRef>
          </c:cat>
          <c:val>
            <c:numRef>
              <c:f>KWS!$G$3:$G$30</c:f>
              <c:numCache>
                <c:formatCode>_(* #,##0_);_(* \(#,##0\);_(* "-"_);_(@_)</c:formatCode>
                <c:ptCount val="28"/>
                <c:pt idx="0">
                  <c:v>55005990</c:v>
                </c:pt>
                <c:pt idx="1">
                  <c:v>62816884</c:v>
                </c:pt>
                <c:pt idx="2">
                  <c:v>63249638</c:v>
                </c:pt>
                <c:pt idx="3">
                  <c:v>64080114</c:v>
                </c:pt>
                <c:pt idx="4">
                  <c:v>55774560</c:v>
                </c:pt>
                <c:pt idx="5">
                  <c:v>55185470</c:v>
                </c:pt>
                <c:pt idx="6">
                  <c:v>61040852</c:v>
                </c:pt>
                <c:pt idx="7">
                  <c:v>62624698</c:v>
                </c:pt>
                <c:pt idx="8">
                  <c:v>63951816</c:v>
                </c:pt>
                <c:pt idx="9">
                  <c:v>52579014</c:v>
                </c:pt>
                <c:pt idx="10">
                  <c:v>54864604</c:v>
                </c:pt>
                <c:pt idx="11">
                  <c:v>55641072</c:v>
                </c:pt>
                <c:pt idx="12">
                  <c:v>59083896</c:v>
                </c:pt>
                <c:pt idx="13">
                  <c:v>58979194</c:v>
                </c:pt>
                <c:pt idx="14">
                  <c:v>60525298</c:v>
                </c:pt>
                <c:pt idx="15">
                  <c:v>75010228</c:v>
                </c:pt>
                <c:pt idx="16">
                  <c:v>58611554</c:v>
                </c:pt>
                <c:pt idx="17">
                  <c:v>60098154</c:v>
                </c:pt>
                <c:pt idx="18">
                  <c:v>64291856</c:v>
                </c:pt>
                <c:pt idx="19">
                  <c:v>63658652</c:v>
                </c:pt>
                <c:pt idx="20">
                  <c:v>63537852</c:v>
                </c:pt>
                <c:pt idx="21">
                  <c:v>57767962</c:v>
                </c:pt>
                <c:pt idx="22">
                  <c:v>56935634</c:v>
                </c:pt>
                <c:pt idx="23">
                  <c:v>57772482</c:v>
                </c:pt>
                <c:pt idx="24">
                  <c:v>55746202</c:v>
                </c:pt>
                <c:pt idx="25">
                  <c:v>63567700</c:v>
                </c:pt>
                <c:pt idx="26">
                  <c:v>61512228</c:v>
                </c:pt>
                <c:pt idx="27" formatCode="General">
                  <c:v>4953414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1C-486D-87B0-98F67A4DAB00}"/>
            </c:ext>
          </c:extLst>
        </c:ser>
        <c:ser>
          <c:idx val="1"/>
          <c:order val="1"/>
          <c:tx>
            <c:strRef>
              <c:f>KWS!$H$2</c:f>
              <c:strCache>
                <c:ptCount val="1"/>
                <c:pt idx="0">
                  <c:v> Unmapped 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KWS!$F$3:$F$30</c:f>
              <c:strCache>
                <c:ptCount val="28"/>
                <c:pt idx="0">
                  <c:v>K1_1</c:v>
                </c:pt>
                <c:pt idx="1">
                  <c:v>K1_2</c:v>
                </c:pt>
                <c:pt idx="2">
                  <c:v>K1_3</c:v>
                </c:pt>
                <c:pt idx="3">
                  <c:v>K2_1</c:v>
                </c:pt>
                <c:pt idx="4">
                  <c:v>K2_2</c:v>
                </c:pt>
                <c:pt idx="5">
                  <c:v>K2_3</c:v>
                </c:pt>
                <c:pt idx="6">
                  <c:v>K3_1</c:v>
                </c:pt>
                <c:pt idx="7">
                  <c:v>K3_2</c:v>
                </c:pt>
                <c:pt idx="8">
                  <c:v>K3_3</c:v>
                </c:pt>
                <c:pt idx="9">
                  <c:v>K4_1</c:v>
                </c:pt>
                <c:pt idx="10">
                  <c:v>K4_2</c:v>
                </c:pt>
                <c:pt idx="11">
                  <c:v>K4_3</c:v>
                </c:pt>
                <c:pt idx="12">
                  <c:v>K5_1</c:v>
                </c:pt>
                <c:pt idx="13">
                  <c:v>K5_2</c:v>
                </c:pt>
                <c:pt idx="14">
                  <c:v>K5_3</c:v>
                </c:pt>
                <c:pt idx="15">
                  <c:v>K6_1</c:v>
                </c:pt>
                <c:pt idx="16">
                  <c:v>K6_2</c:v>
                </c:pt>
                <c:pt idx="17">
                  <c:v>K6_3</c:v>
                </c:pt>
                <c:pt idx="18">
                  <c:v>K7_1</c:v>
                </c:pt>
                <c:pt idx="19">
                  <c:v>K7_2</c:v>
                </c:pt>
                <c:pt idx="20">
                  <c:v>K7_3</c:v>
                </c:pt>
                <c:pt idx="21">
                  <c:v>K8_1</c:v>
                </c:pt>
                <c:pt idx="22">
                  <c:v>K8_2</c:v>
                </c:pt>
                <c:pt idx="23">
                  <c:v>K8_3</c:v>
                </c:pt>
                <c:pt idx="24">
                  <c:v>K9_1</c:v>
                </c:pt>
                <c:pt idx="25">
                  <c:v>K9_2</c:v>
                </c:pt>
                <c:pt idx="26">
                  <c:v>K9_3</c:v>
                </c:pt>
                <c:pt idx="27">
                  <c:v>WGS</c:v>
                </c:pt>
              </c:strCache>
            </c:strRef>
          </c:cat>
          <c:val>
            <c:numRef>
              <c:f>KWS!$H$3:$H$30</c:f>
              <c:numCache>
                <c:formatCode>_(* #,##0_);_(* \(#,##0\);_(* "-"_);_(@_)</c:formatCode>
                <c:ptCount val="28"/>
                <c:pt idx="0">
                  <c:v>1210063</c:v>
                </c:pt>
                <c:pt idx="1">
                  <c:v>1175424</c:v>
                </c:pt>
                <c:pt idx="2">
                  <c:v>1095028</c:v>
                </c:pt>
                <c:pt idx="3">
                  <c:v>1136322</c:v>
                </c:pt>
                <c:pt idx="4">
                  <c:v>1065954</c:v>
                </c:pt>
                <c:pt idx="5">
                  <c:v>1133441</c:v>
                </c:pt>
                <c:pt idx="6">
                  <c:v>1376054</c:v>
                </c:pt>
                <c:pt idx="7">
                  <c:v>1227564</c:v>
                </c:pt>
                <c:pt idx="8">
                  <c:v>1204590</c:v>
                </c:pt>
                <c:pt idx="9">
                  <c:v>1009156</c:v>
                </c:pt>
                <c:pt idx="10">
                  <c:v>1167051</c:v>
                </c:pt>
                <c:pt idx="11">
                  <c:v>1061738</c:v>
                </c:pt>
                <c:pt idx="12">
                  <c:v>987093</c:v>
                </c:pt>
                <c:pt idx="13">
                  <c:v>1193863</c:v>
                </c:pt>
                <c:pt idx="14">
                  <c:v>1109690</c:v>
                </c:pt>
                <c:pt idx="15">
                  <c:v>1365187</c:v>
                </c:pt>
                <c:pt idx="16">
                  <c:v>1011875</c:v>
                </c:pt>
                <c:pt idx="17">
                  <c:v>2156691</c:v>
                </c:pt>
                <c:pt idx="18">
                  <c:v>1360185</c:v>
                </c:pt>
                <c:pt idx="19">
                  <c:v>1410901</c:v>
                </c:pt>
                <c:pt idx="20">
                  <c:v>1433935</c:v>
                </c:pt>
                <c:pt idx="21">
                  <c:v>1309196</c:v>
                </c:pt>
                <c:pt idx="22">
                  <c:v>1447779</c:v>
                </c:pt>
                <c:pt idx="23">
                  <c:v>1332595</c:v>
                </c:pt>
                <c:pt idx="24">
                  <c:v>894970</c:v>
                </c:pt>
                <c:pt idx="25">
                  <c:v>1131447</c:v>
                </c:pt>
                <c:pt idx="26">
                  <c:v>936827</c:v>
                </c:pt>
                <c:pt idx="27" formatCode="General">
                  <c:v>17757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B1C-486D-87B0-98F67A4DAB00}"/>
            </c:ext>
          </c:extLst>
        </c:ser>
        <c:ser>
          <c:idx val="2"/>
          <c:order val="2"/>
          <c:tx>
            <c:strRef>
              <c:f>KWS!$I$2</c:f>
              <c:strCache>
                <c:ptCount val="1"/>
                <c:pt idx="0">
                  <c:v> Contaminants 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KWS!$F$3:$F$30</c:f>
              <c:strCache>
                <c:ptCount val="28"/>
                <c:pt idx="0">
                  <c:v>K1_1</c:v>
                </c:pt>
                <c:pt idx="1">
                  <c:v>K1_2</c:v>
                </c:pt>
                <c:pt idx="2">
                  <c:v>K1_3</c:v>
                </c:pt>
                <c:pt idx="3">
                  <c:v>K2_1</c:v>
                </c:pt>
                <c:pt idx="4">
                  <c:v>K2_2</c:v>
                </c:pt>
                <c:pt idx="5">
                  <c:v>K2_3</c:v>
                </c:pt>
                <c:pt idx="6">
                  <c:v>K3_1</c:v>
                </c:pt>
                <c:pt idx="7">
                  <c:v>K3_2</c:v>
                </c:pt>
                <c:pt idx="8">
                  <c:v>K3_3</c:v>
                </c:pt>
                <c:pt idx="9">
                  <c:v>K4_1</c:v>
                </c:pt>
                <c:pt idx="10">
                  <c:v>K4_2</c:v>
                </c:pt>
                <c:pt idx="11">
                  <c:v>K4_3</c:v>
                </c:pt>
                <c:pt idx="12">
                  <c:v>K5_1</c:v>
                </c:pt>
                <c:pt idx="13">
                  <c:v>K5_2</c:v>
                </c:pt>
                <c:pt idx="14">
                  <c:v>K5_3</c:v>
                </c:pt>
                <c:pt idx="15">
                  <c:v>K6_1</c:v>
                </c:pt>
                <c:pt idx="16">
                  <c:v>K6_2</c:v>
                </c:pt>
                <c:pt idx="17">
                  <c:v>K6_3</c:v>
                </c:pt>
                <c:pt idx="18">
                  <c:v>K7_1</c:v>
                </c:pt>
                <c:pt idx="19">
                  <c:v>K7_2</c:v>
                </c:pt>
                <c:pt idx="20">
                  <c:v>K7_3</c:v>
                </c:pt>
                <c:pt idx="21">
                  <c:v>K8_1</c:v>
                </c:pt>
                <c:pt idx="22">
                  <c:v>K8_2</c:v>
                </c:pt>
                <c:pt idx="23">
                  <c:v>K8_3</c:v>
                </c:pt>
                <c:pt idx="24">
                  <c:v>K9_1</c:v>
                </c:pt>
                <c:pt idx="25">
                  <c:v>K9_2</c:v>
                </c:pt>
                <c:pt idx="26">
                  <c:v>K9_3</c:v>
                </c:pt>
                <c:pt idx="27">
                  <c:v>WGS</c:v>
                </c:pt>
              </c:strCache>
            </c:strRef>
          </c:cat>
          <c:val>
            <c:numRef>
              <c:f>KWS!$I$3:$I$30</c:f>
              <c:numCache>
                <c:formatCode>General</c:formatCode>
                <c:ptCount val="28"/>
                <c:pt idx="27" formatCode="#,##0">
                  <c:v>1987901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B1C-486D-87B0-98F67A4DAB00}"/>
            </c:ext>
          </c:extLst>
        </c:ser>
        <c:ser>
          <c:idx val="3"/>
          <c:order val="3"/>
          <c:tx>
            <c:strRef>
              <c:f>KWS!$J$2</c:f>
              <c:strCache>
                <c:ptCount val="1"/>
                <c:pt idx="0">
                  <c:v> Low quality 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KWS!$F$3:$F$30</c:f>
              <c:strCache>
                <c:ptCount val="28"/>
                <c:pt idx="0">
                  <c:v>K1_1</c:v>
                </c:pt>
                <c:pt idx="1">
                  <c:v>K1_2</c:v>
                </c:pt>
                <c:pt idx="2">
                  <c:v>K1_3</c:v>
                </c:pt>
                <c:pt idx="3">
                  <c:v>K2_1</c:v>
                </c:pt>
                <c:pt idx="4">
                  <c:v>K2_2</c:v>
                </c:pt>
                <c:pt idx="5">
                  <c:v>K2_3</c:v>
                </c:pt>
                <c:pt idx="6">
                  <c:v>K3_1</c:v>
                </c:pt>
                <c:pt idx="7">
                  <c:v>K3_2</c:v>
                </c:pt>
                <c:pt idx="8">
                  <c:v>K3_3</c:v>
                </c:pt>
                <c:pt idx="9">
                  <c:v>K4_1</c:v>
                </c:pt>
                <c:pt idx="10">
                  <c:v>K4_2</c:v>
                </c:pt>
                <c:pt idx="11">
                  <c:v>K4_3</c:v>
                </c:pt>
                <c:pt idx="12">
                  <c:v>K5_1</c:v>
                </c:pt>
                <c:pt idx="13">
                  <c:v>K5_2</c:v>
                </c:pt>
                <c:pt idx="14">
                  <c:v>K5_3</c:v>
                </c:pt>
                <c:pt idx="15">
                  <c:v>K6_1</c:v>
                </c:pt>
                <c:pt idx="16">
                  <c:v>K6_2</c:v>
                </c:pt>
                <c:pt idx="17">
                  <c:v>K6_3</c:v>
                </c:pt>
                <c:pt idx="18">
                  <c:v>K7_1</c:v>
                </c:pt>
                <c:pt idx="19">
                  <c:v>K7_2</c:v>
                </c:pt>
                <c:pt idx="20">
                  <c:v>K7_3</c:v>
                </c:pt>
                <c:pt idx="21">
                  <c:v>K8_1</c:v>
                </c:pt>
                <c:pt idx="22">
                  <c:v>K8_2</c:v>
                </c:pt>
                <c:pt idx="23">
                  <c:v>K8_3</c:v>
                </c:pt>
                <c:pt idx="24">
                  <c:v>K9_1</c:v>
                </c:pt>
                <c:pt idx="25">
                  <c:v>K9_2</c:v>
                </c:pt>
                <c:pt idx="26">
                  <c:v>K9_3</c:v>
                </c:pt>
                <c:pt idx="27">
                  <c:v>WGS</c:v>
                </c:pt>
              </c:strCache>
            </c:strRef>
          </c:cat>
          <c:val>
            <c:numRef>
              <c:f>KWS!$J$3:$J$30</c:f>
              <c:numCache>
                <c:formatCode>_(* #,##0_);_(* \(#,##0\);_(* "-"_);_(@_)</c:formatCode>
                <c:ptCount val="28"/>
                <c:pt idx="0">
                  <c:v>623227</c:v>
                </c:pt>
                <c:pt idx="1">
                  <c:v>626620</c:v>
                </c:pt>
                <c:pt idx="2">
                  <c:v>619886</c:v>
                </c:pt>
                <c:pt idx="3">
                  <c:v>625214</c:v>
                </c:pt>
                <c:pt idx="4">
                  <c:v>592966</c:v>
                </c:pt>
                <c:pt idx="5">
                  <c:v>588723</c:v>
                </c:pt>
                <c:pt idx="6">
                  <c:v>678498</c:v>
                </c:pt>
                <c:pt idx="7">
                  <c:v>648762</c:v>
                </c:pt>
                <c:pt idx="8">
                  <c:v>636812</c:v>
                </c:pt>
                <c:pt idx="9">
                  <c:v>550070</c:v>
                </c:pt>
                <c:pt idx="10">
                  <c:v>566309</c:v>
                </c:pt>
                <c:pt idx="11">
                  <c:v>567670</c:v>
                </c:pt>
                <c:pt idx="12">
                  <c:v>559167</c:v>
                </c:pt>
                <c:pt idx="13">
                  <c:v>671301</c:v>
                </c:pt>
                <c:pt idx="14">
                  <c:v>623278</c:v>
                </c:pt>
                <c:pt idx="15">
                  <c:v>754577</c:v>
                </c:pt>
                <c:pt idx="16">
                  <c:v>581825</c:v>
                </c:pt>
                <c:pt idx="17">
                  <c:v>577577</c:v>
                </c:pt>
                <c:pt idx="18">
                  <c:v>625349</c:v>
                </c:pt>
                <c:pt idx="19">
                  <c:v>700559</c:v>
                </c:pt>
                <c:pt idx="20">
                  <c:v>703191</c:v>
                </c:pt>
                <c:pt idx="21">
                  <c:v>552868</c:v>
                </c:pt>
                <c:pt idx="22">
                  <c:v>587041</c:v>
                </c:pt>
                <c:pt idx="23">
                  <c:v>569289</c:v>
                </c:pt>
                <c:pt idx="24">
                  <c:v>544092</c:v>
                </c:pt>
                <c:pt idx="25">
                  <c:v>648949</c:v>
                </c:pt>
                <c:pt idx="26">
                  <c:v>553175</c:v>
                </c:pt>
                <c:pt idx="27" formatCode="#,##0">
                  <c:v>398893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B1C-486D-87B0-98F67A4DAB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5977071"/>
        <c:axId val="145978319"/>
      </c:barChart>
      <c:catAx>
        <c:axId val="1459770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978319"/>
        <c:crosses val="autoZero"/>
        <c:auto val="1"/>
        <c:lblAlgn val="ctr"/>
        <c:lblOffset val="100"/>
        <c:noMultiLvlLbl val="0"/>
      </c:catAx>
      <c:valAx>
        <c:axId val="1459783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97707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746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82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617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445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55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125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466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55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8106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22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07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AAC372-3B2C-4891-8843-03DE5C1332A4}" type="datetimeFigureOut">
              <a:rPr lang="en-US" smtClean="0"/>
              <a:t>9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806EF-4D3C-42A1-A5F4-217AC10B8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831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2.png"/><Relationship Id="rId18" Type="http://schemas.openxmlformats.org/officeDocument/2006/relationships/image" Target="../media/image16.png"/><Relationship Id="rId3" Type="http://schemas.openxmlformats.org/officeDocument/2006/relationships/image" Target="../media/image6.png"/><Relationship Id="rId7" Type="http://schemas.microsoft.com/office/2007/relationships/hdphoto" Target="../media/hdphoto2.wdp"/><Relationship Id="rId12" Type="http://schemas.microsoft.com/office/2007/relationships/hdphoto" Target="../media/hdphoto4.wdp"/><Relationship Id="rId17" Type="http://schemas.openxmlformats.org/officeDocument/2006/relationships/image" Target="../media/image15.png"/><Relationship Id="rId2" Type="http://schemas.openxmlformats.org/officeDocument/2006/relationships/image" Target="../media/image5.png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1.png"/><Relationship Id="rId5" Type="http://schemas.microsoft.com/office/2007/relationships/hdphoto" Target="../media/hdphoto1.wdp"/><Relationship Id="rId15" Type="http://schemas.openxmlformats.org/officeDocument/2006/relationships/image" Target="../media/image13.png"/><Relationship Id="rId10" Type="http://schemas.microsoft.com/office/2007/relationships/hdphoto" Target="../media/hdphoto3.wdp"/><Relationship Id="rId4" Type="http://schemas.openxmlformats.org/officeDocument/2006/relationships/image" Target="../media/image7.png"/><Relationship Id="rId9" Type="http://schemas.openxmlformats.org/officeDocument/2006/relationships/image" Target="../media/image10.png"/><Relationship Id="rId14" Type="http://schemas.microsoft.com/office/2007/relationships/hdphoto" Target="../media/hdphoto5.wd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사각형: 둥근 모서리 28">
            <a:extLst>
              <a:ext uri="{FF2B5EF4-FFF2-40B4-BE49-F238E27FC236}">
                <a16:creationId xmlns:a16="http://schemas.microsoft.com/office/drawing/2014/main" id="{AF87689B-7937-4979-A719-EB075056E2FE}"/>
              </a:ext>
            </a:extLst>
          </p:cNvPr>
          <p:cNvSpPr/>
          <p:nvPr/>
        </p:nvSpPr>
        <p:spPr>
          <a:xfrm>
            <a:off x="551384" y="1041421"/>
            <a:ext cx="4248472" cy="1632651"/>
          </a:xfrm>
          <a:prstGeom prst="roundRect">
            <a:avLst>
              <a:gd name="adj" fmla="val 10597"/>
            </a:avLst>
          </a:prstGeom>
          <a:noFill/>
          <a:ln w="28575"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>
              <a:lnSpc>
                <a:spcPct val="150000"/>
              </a:lnSpc>
            </a:pP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3" name="사각형: 둥근 모서리 2">
            <a:extLst>
              <a:ext uri="{FF2B5EF4-FFF2-40B4-BE49-F238E27FC236}">
                <a16:creationId xmlns:a16="http://schemas.microsoft.com/office/drawing/2014/main" id="{843C22B1-B524-458A-AD3C-A8D957D4A626}"/>
              </a:ext>
            </a:extLst>
          </p:cNvPr>
          <p:cNvSpPr/>
          <p:nvPr/>
        </p:nvSpPr>
        <p:spPr>
          <a:xfrm>
            <a:off x="606417" y="1244536"/>
            <a:ext cx="941578" cy="598287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Illumina </a:t>
            </a:r>
          </a:p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(JEF: </a:t>
            </a:r>
            <a:r>
              <a:rPr lang="en-US" altLang="ko-KR" sz="1000" dirty="0">
                <a:solidFill>
                  <a:srgbClr val="FF0000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315.10</a:t>
            </a:r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 X/</a:t>
            </a:r>
          </a:p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KWS: 328.69X)</a:t>
            </a: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4" name="사각형: 둥근 모서리 5">
            <a:extLst>
              <a:ext uri="{FF2B5EF4-FFF2-40B4-BE49-F238E27FC236}">
                <a16:creationId xmlns:a16="http://schemas.microsoft.com/office/drawing/2014/main" id="{37094326-2B99-4F2C-8AE7-A879F5215807}"/>
              </a:ext>
            </a:extLst>
          </p:cNvPr>
          <p:cNvSpPr/>
          <p:nvPr/>
        </p:nvSpPr>
        <p:spPr>
          <a:xfrm>
            <a:off x="2049879" y="1413935"/>
            <a:ext cx="821578" cy="252346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Clean Reads</a:t>
            </a: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cxnSp>
        <p:nvCxnSpPr>
          <p:cNvPr id="5" name="직선 화살표 연결선 10">
            <a:extLst>
              <a:ext uri="{FF2B5EF4-FFF2-40B4-BE49-F238E27FC236}">
                <a16:creationId xmlns:a16="http://schemas.microsoft.com/office/drawing/2014/main" id="{E13148A9-2C06-43BC-94F3-DEA0067BCF79}"/>
              </a:ext>
            </a:extLst>
          </p:cNvPr>
          <p:cNvCxnSpPr>
            <a:cxnSpLocks/>
            <a:stCxn id="3" idx="3"/>
            <a:endCxn id="4" idx="1"/>
          </p:cNvCxnSpPr>
          <p:nvPr/>
        </p:nvCxnSpPr>
        <p:spPr>
          <a:xfrm flipV="1">
            <a:off x="1547995" y="1540108"/>
            <a:ext cx="501884" cy="3572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3D07FC37-FDAA-4016-BB3D-32B2E5BAF0EC}"/>
              </a:ext>
            </a:extLst>
          </p:cNvPr>
          <p:cNvSpPr txBox="1"/>
          <p:nvPr/>
        </p:nvSpPr>
        <p:spPr>
          <a:xfrm>
            <a:off x="1431347" y="1195757"/>
            <a:ext cx="1440160" cy="194319"/>
          </a:xfrm>
          <a:prstGeom prst="rect">
            <a:avLst/>
          </a:prstGeom>
          <a:noFill/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b="1" dirty="0" err="1">
                <a:latin typeface="Palatino Linotype" panose="02040502050505030304" pitchFamily="18" charset="0"/>
                <a:ea typeface="+mn-ea"/>
              </a:rPr>
              <a:t>Trimmomatic</a:t>
            </a:r>
            <a:r>
              <a:rPr lang="en-US" altLang="ko-KR" sz="1000" b="1" dirty="0">
                <a:latin typeface="Palatino Linotype" panose="02040502050505030304" pitchFamily="18" charset="0"/>
                <a:ea typeface="+mn-ea"/>
              </a:rPr>
              <a:t> v0.36</a:t>
            </a:r>
            <a:endParaRPr lang="ko-KR" altLang="en-US" sz="1000" b="1" dirty="0" err="1">
              <a:latin typeface="Palatino Linotype" panose="02040502050505030304" pitchFamily="18" charset="0"/>
              <a:ea typeface="+mn-ea"/>
            </a:endParaRPr>
          </a:p>
        </p:txBody>
      </p:sp>
      <p:cxnSp>
        <p:nvCxnSpPr>
          <p:cNvPr id="7" name="직선 화살표 연결선 15">
            <a:extLst>
              <a:ext uri="{FF2B5EF4-FFF2-40B4-BE49-F238E27FC236}">
                <a16:creationId xmlns:a16="http://schemas.microsoft.com/office/drawing/2014/main" id="{F625A7AE-4F24-4F56-BE14-189F435B5B74}"/>
              </a:ext>
            </a:extLst>
          </p:cNvPr>
          <p:cNvCxnSpPr>
            <a:cxnSpLocks/>
            <a:endCxn id="4" idx="3"/>
          </p:cNvCxnSpPr>
          <p:nvPr/>
        </p:nvCxnSpPr>
        <p:spPr>
          <a:xfrm flipH="1">
            <a:off x="2871457" y="1540108"/>
            <a:ext cx="780582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610FB71F-059B-48C0-83F3-6671115958F9}"/>
              </a:ext>
            </a:extLst>
          </p:cNvPr>
          <p:cNvSpPr txBox="1"/>
          <p:nvPr/>
        </p:nvSpPr>
        <p:spPr>
          <a:xfrm>
            <a:off x="2844664" y="1276064"/>
            <a:ext cx="793159" cy="180663"/>
          </a:xfrm>
          <a:prstGeom prst="rect">
            <a:avLst/>
          </a:prstGeom>
          <a:noFill/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b="1" dirty="0">
                <a:latin typeface="Palatino Linotype" panose="02040502050505030304" pitchFamily="18" charset="0"/>
                <a:ea typeface="+mn-ea"/>
              </a:rPr>
              <a:t>Bowtie2</a:t>
            </a:r>
            <a:endParaRPr lang="ko-KR" altLang="en-US" sz="1000" b="1" dirty="0" err="1">
              <a:latin typeface="Palatino Linotype" panose="02040502050505030304" pitchFamily="18" charset="0"/>
              <a:ea typeface="+mn-ea"/>
            </a:endParaRPr>
          </a:p>
        </p:txBody>
      </p:sp>
      <p:cxnSp>
        <p:nvCxnSpPr>
          <p:cNvPr id="9" name="직선 화살표 연결선 23">
            <a:extLst>
              <a:ext uri="{FF2B5EF4-FFF2-40B4-BE49-F238E27FC236}">
                <a16:creationId xmlns:a16="http://schemas.microsoft.com/office/drawing/2014/main" id="{23BD7211-4E25-4235-869A-839C3B41E629}"/>
              </a:ext>
            </a:extLst>
          </p:cNvPr>
          <p:cNvCxnSpPr>
            <a:stCxn id="4" idx="2"/>
            <a:endCxn id="10" idx="0"/>
          </p:cNvCxnSpPr>
          <p:nvPr/>
        </p:nvCxnSpPr>
        <p:spPr>
          <a:xfrm>
            <a:off x="2460668" y="1666281"/>
            <a:ext cx="0" cy="46858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사각형: 둥근 모서리 25">
            <a:extLst>
              <a:ext uri="{FF2B5EF4-FFF2-40B4-BE49-F238E27FC236}">
                <a16:creationId xmlns:a16="http://schemas.microsoft.com/office/drawing/2014/main" id="{3006D2F1-9271-4FF8-8D4B-4443A41B2645}"/>
              </a:ext>
            </a:extLst>
          </p:cNvPr>
          <p:cNvSpPr/>
          <p:nvPr/>
        </p:nvSpPr>
        <p:spPr>
          <a:xfrm>
            <a:off x="1951124" y="2134866"/>
            <a:ext cx="1019088" cy="429873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Genome Size </a:t>
            </a:r>
          </a:p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Estimation</a:t>
            </a: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C30D52-AD1C-4A11-A35D-4A4C8D43ACD7}"/>
              </a:ext>
            </a:extLst>
          </p:cNvPr>
          <p:cNvSpPr txBox="1"/>
          <p:nvPr/>
        </p:nvSpPr>
        <p:spPr>
          <a:xfrm>
            <a:off x="613035" y="826014"/>
            <a:ext cx="2088232" cy="216024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r>
              <a:rPr lang="en-US" altLang="ko-KR" sz="1100" b="1" dirty="0">
                <a:solidFill>
                  <a:schemeClr val="accent3">
                    <a:lumMod val="75000"/>
                  </a:schemeClr>
                </a:solidFill>
                <a:latin typeface="Palatino Linotype" panose="02040502050505030304" pitchFamily="18" charset="0"/>
                <a:ea typeface="+mn-ea"/>
              </a:rPr>
              <a:t>A. Short Read based workflow</a:t>
            </a:r>
            <a:endParaRPr lang="ko-KR" altLang="en-US" sz="1100" b="1" dirty="0" err="1">
              <a:solidFill>
                <a:schemeClr val="accent3">
                  <a:lumMod val="75000"/>
                </a:schemeClr>
              </a:solidFill>
              <a:latin typeface="Palatino Linotype" panose="02040502050505030304" pitchFamily="18" charset="0"/>
              <a:ea typeface="+mn-ea"/>
            </a:endParaRPr>
          </a:p>
        </p:txBody>
      </p:sp>
      <p:grpSp>
        <p:nvGrpSpPr>
          <p:cNvPr id="12" name="그룹 43">
            <a:extLst>
              <a:ext uri="{FF2B5EF4-FFF2-40B4-BE49-F238E27FC236}">
                <a16:creationId xmlns:a16="http://schemas.microsoft.com/office/drawing/2014/main" id="{8EBF3102-01C2-49AA-9C31-6CF17FE67274}"/>
              </a:ext>
            </a:extLst>
          </p:cNvPr>
          <p:cNvGrpSpPr/>
          <p:nvPr/>
        </p:nvGrpSpPr>
        <p:grpSpPr>
          <a:xfrm>
            <a:off x="747124" y="3116158"/>
            <a:ext cx="3841698" cy="1309461"/>
            <a:chOff x="756432" y="3273205"/>
            <a:chExt cx="3972272" cy="1354659"/>
          </a:xfrm>
        </p:grpSpPr>
        <p:sp>
          <p:nvSpPr>
            <p:cNvPr id="13" name="사각형: 둥근 모서리 32">
              <a:extLst>
                <a:ext uri="{FF2B5EF4-FFF2-40B4-BE49-F238E27FC236}">
                  <a16:creationId xmlns:a16="http://schemas.microsoft.com/office/drawing/2014/main" id="{536B34A3-D0E2-430E-88B4-BDF7CE28EC78}"/>
                </a:ext>
              </a:extLst>
            </p:cNvPr>
            <p:cNvSpPr/>
            <p:nvPr/>
          </p:nvSpPr>
          <p:spPr>
            <a:xfrm>
              <a:off x="756432" y="3273205"/>
              <a:ext cx="1656184" cy="546391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PacBio</a:t>
              </a:r>
            </a:p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 (JEF: 137.48</a:t>
              </a:r>
              <a:r>
                <a:rPr lang="en-US" altLang="ko-KR" sz="1000" dirty="0">
                  <a:solidFill>
                    <a:srgbClr val="FF0000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 </a:t>
              </a:r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X/</a:t>
              </a:r>
            </a:p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KWS: 160.38X)</a:t>
              </a:r>
              <a:endParaRPr lang="ko-KR" altLang="en-US" sz="1000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sp>
          <p:nvSpPr>
            <p:cNvPr id="14" name="사각형: 둥근 모서리 33">
              <a:extLst>
                <a:ext uri="{FF2B5EF4-FFF2-40B4-BE49-F238E27FC236}">
                  <a16:creationId xmlns:a16="http://schemas.microsoft.com/office/drawing/2014/main" id="{6080017C-7EFB-4D6C-923C-C323FAA0092F}"/>
                </a:ext>
              </a:extLst>
            </p:cNvPr>
            <p:cNvSpPr/>
            <p:nvPr/>
          </p:nvSpPr>
          <p:spPr>
            <a:xfrm>
              <a:off x="756432" y="4005064"/>
              <a:ext cx="1656184" cy="6228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Processed Reads</a:t>
              </a:r>
            </a:p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(HQ Reads)</a:t>
              </a:r>
              <a:endParaRPr lang="ko-KR" altLang="en-US" sz="1000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cxnSp>
          <p:nvCxnSpPr>
            <p:cNvPr id="15" name="직선 화살표 연결선 35">
              <a:extLst>
                <a:ext uri="{FF2B5EF4-FFF2-40B4-BE49-F238E27FC236}">
                  <a16:creationId xmlns:a16="http://schemas.microsoft.com/office/drawing/2014/main" id="{F7DC116D-6649-4050-93E8-D71BBE6FF590}"/>
                </a:ext>
              </a:extLst>
            </p:cNvPr>
            <p:cNvCxnSpPr>
              <a:cxnSpLocks/>
              <a:stCxn id="13" idx="2"/>
              <a:endCxn id="14" idx="0"/>
            </p:cNvCxnSpPr>
            <p:nvPr/>
          </p:nvCxnSpPr>
          <p:spPr>
            <a:xfrm>
              <a:off x="1584525" y="3819596"/>
              <a:ext cx="0" cy="18546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사각형: 둥근 모서리 36">
              <a:extLst>
                <a:ext uri="{FF2B5EF4-FFF2-40B4-BE49-F238E27FC236}">
                  <a16:creationId xmlns:a16="http://schemas.microsoft.com/office/drawing/2014/main" id="{CD725865-EC99-4A0F-AD87-099A7AC862EF}"/>
                </a:ext>
              </a:extLst>
            </p:cNvPr>
            <p:cNvSpPr/>
            <p:nvPr/>
          </p:nvSpPr>
          <p:spPr>
            <a:xfrm>
              <a:off x="2843548" y="4005064"/>
              <a:ext cx="1885156" cy="6228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i="1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de novo</a:t>
              </a:r>
              <a:endPara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Assembled Contigs</a:t>
              </a:r>
              <a:endParaRPr lang="ko-KR" altLang="en-US" sz="1000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sp>
          <p:nvSpPr>
            <p:cNvPr id="17" name="사각형: 둥근 모서리 37">
              <a:extLst>
                <a:ext uri="{FF2B5EF4-FFF2-40B4-BE49-F238E27FC236}">
                  <a16:creationId xmlns:a16="http://schemas.microsoft.com/office/drawing/2014/main" id="{88DA0F3E-57C1-4008-B73D-E1CA241B746F}"/>
                </a:ext>
              </a:extLst>
            </p:cNvPr>
            <p:cNvSpPr/>
            <p:nvPr/>
          </p:nvSpPr>
          <p:spPr>
            <a:xfrm>
              <a:off x="2958034" y="3273205"/>
              <a:ext cx="1656184" cy="43204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i="1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Filtered</a:t>
              </a:r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  Contigs</a:t>
              </a:r>
              <a:endParaRPr lang="ko-KR" altLang="en-US" sz="1000" i="1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cxnSp>
          <p:nvCxnSpPr>
            <p:cNvPr id="18" name="직선 화살표 연결선 39">
              <a:extLst>
                <a:ext uri="{FF2B5EF4-FFF2-40B4-BE49-F238E27FC236}">
                  <a16:creationId xmlns:a16="http://schemas.microsoft.com/office/drawing/2014/main" id="{486CD9DC-B9BE-449F-8545-2AA56CAC290E}"/>
                </a:ext>
              </a:extLst>
            </p:cNvPr>
            <p:cNvCxnSpPr>
              <a:stCxn id="14" idx="3"/>
              <a:endCxn id="16" idx="1"/>
            </p:cNvCxnSpPr>
            <p:nvPr/>
          </p:nvCxnSpPr>
          <p:spPr>
            <a:xfrm>
              <a:off x="2412616" y="4316464"/>
              <a:ext cx="430932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직선 화살표 연결선 41">
              <a:extLst>
                <a:ext uri="{FF2B5EF4-FFF2-40B4-BE49-F238E27FC236}">
                  <a16:creationId xmlns:a16="http://schemas.microsoft.com/office/drawing/2014/main" id="{03FFD065-05F8-4534-B078-DF91E992E549}"/>
                </a:ext>
              </a:extLst>
            </p:cNvPr>
            <p:cNvCxnSpPr>
              <a:stCxn id="16" idx="0"/>
              <a:endCxn id="17" idx="2"/>
            </p:cNvCxnSpPr>
            <p:nvPr/>
          </p:nvCxnSpPr>
          <p:spPr>
            <a:xfrm flipV="1">
              <a:off x="3786126" y="3705253"/>
              <a:ext cx="0" cy="29981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사각형: 둥근 모서리 42">
            <a:extLst>
              <a:ext uri="{FF2B5EF4-FFF2-40B4-BE49-F238E27FC236}">
                <a16:creationId xmlns:a16="http://schemas.microsoft.com/office/drawing/2014/main" id="{1D499521-2570-4F4D-B35D-63EBD6BC1437}"/>
              </a:ext>
            </a:extLst>
          </p:cNvPr>
          <p:cNvSpPr/>
          <p:nvPr/>
        </p:nvSpPr>
        <p:spPr>
          <a:xfrm>
            <a:off x="551385" y="2996954"/>
            <a:ext cx="4161042" cy="1622984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>
              <a:lnSpc>
                <a:spcPct val="150000"/>
              </a:lnSpc>
            </a:pP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B212225-40D7-4B5F-B543-3C4366F15756}"/>
              </a:ext>
            </a:extLst>
          </p:cNvPr>
          <p:cNvSpPr txBox="1"/>
          <p:nvPr/>
        </p:nvSpPr>
        <p:spPr>
          <a:xfrm>
            <a:off x="634871" y="2746535"/>
            <a:ext cx="2088232" cy="216024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r>
              <a:rPr lang="en-US" altLang="ko-KR" sz="1100" b="1" dirty="0">
                <a:solidFill>
                  <a:schemeClr val="accent3">
                    <a:lumMod val="75000"/>
                  </a:schemeClr>
                </a:solidFill>
                <a:latin typeface="Palatino Linotype" panose="02040502050505030304" pitchFamily="18" charset="0"/>
                <a:ea typeface="+mn-ea"/>
              </a:rPr>
              <a:t>B. Long Read based workflow</a:t>
            </a:r>
            <a:endParaRPr lang="ko-KR" altLang="en-US" sz="1100" b="1" dirty="0" err="1">
              <a:solidFill>
                <a:schemeClr val="accent3">
                  <a:lumMod val="75000"/>
                </a:schemeClr>
              </a:solidFill>
              <a:latin typeface="Palatino Linotype" panose="02040502050505030304" pitchFamily="18" charset="0"/>
              <a:ea typeface="+mn-ea"/>
            </a:endParaRPr>
          </a:p>
        </p:txBody>
      </p:sp>
      <p:cxnSp>
        <p:nvCxnSpPr>
          <p:cNvPr id="22" name="직선 화살표 연결선 47">
            <a:extLst>
              <a:ext uri="{FF2B5EF4-FFF2-40B4-BE49-F238E27FC236}">
                <a16:creationId xmlns:a16="http://schemas.microsoft.com/office/drawing/2014/main" id="{1180C388-DCD8-48E7-BD05-4086F6146102}"/>
              </a:ext>
            </a:extLst>
          </p:cNvPr>
          <p:cNvCxnSpPr>
            <a:stCxn id="17" idx="3"/>
            <a:endCxn id="24" idx="1"/>
          </p:cNvCxnSpPr>
          <p:nvPr/>
        </p:nvCxnSpPr>
        <p:spPr>
          <a:xfrm>
            <a:off x="4478099" y="3324975"/>
            <a:ext cx="925025" cy="692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그룹 75">
            <a:extLst>
              <a:ext uri="{FF2B5EF4-FFF2-40B4-BE49-F238E27FC236}">
                <a16:creationId xmlns:a16="http://schemas.microsoft.com/office/drawing/2014/main" id="{B0FE8463-49AD-4CD4-B69C-FEE5D1C469FE}"/>
              </a:ext>
            </a:extLst>
          </p:cNvPr>
          <p:cNvGrpSpPr/>
          <p:nvPr/>
        </p:nvGrpSpPr>
        <p:grpSpPr>
          <a:xfrm>
            <a:off x="5403124" y="3109643"/>
            <a:ext cx="5547349" cy="1411323"/>
            <a:chOff x="5372188" y="3460494"/>
            <a:chExt cx="5547349" cy="1411323"/>
          </a:xfrm>
        </p:grpSpPr>
        <p:sp>
          <p:nvSpPr>
            <p:cNvPr id="24" name="사각형: 둥근 모서리 45">
              <a:extLst>
                <a:ext uri="{FF2B5EF4-FFF2-40B4-BE49-F238E27FC236}">
                  <a16:creationId xmlns:a16="http://schemas.microsoft.com/office/drawing/2014/main" id="{84B90114-C545-4840-A1FB-3ADAFBA91390}"/>
                </a:ext>
              </a:extLst>
            </p:cNvPr>
            <p:cNvSpPr/>
            <p:nvPr/>
          </p:nvSpPr>
          <p:spPr>
            <a:xfrm>
              <a:off x="5372188" y="3460494"/>
              <a:ext cx="1204207" cy="432048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i="1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de novo</a:t>
              </a:r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  Repeats</a:t>
              </a:r>
              <a:endParaRPr lang="ko-KR" altLang="en-US" sz="1000" i="1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sp>
          <p:nvSpPr>
            <p:cNvPr id="25" name="사각형: 둥근 모서리 48">
              <a:extLst>
                <a:ext uri="{FF2B5EF4-FFF2-40B4-BE49-F238E27FC236}">
                  <a16:creationId xmlns:a16="http://schemas.microsoft.com/office/drawing/2014/main" id="{6C85E526-6828-4CD5-8E73-7842DBCCB099}"/>
                </a:ext>
              </a:extLst>
            </p:cNvPr>
            <p:cNvSpPr/>
            <p:nvPr/>
          </p:nvSpPr>
          <p:spPr>
            <a:xfrm>
              <a:off x="7262994" y="3467304"/>
              <a:ext cx="1980280" cy="43204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Masked Draft Genome</a:t>
              </a:r>
              <a:endParaRPr lang="ko-KR" altLang="en-US" sz="1000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sp>
          <p:nvSpPr>
            <p:cNvPr id="26" name="사각형: 둥근 모서리 49">
              <a:extLst>
                <a:ext uri="{FF2B5EF4-FFF2-40B4-BE49-F238E27FC236}">
                  <a16:creationId xmlns:a16="http://schemas.microsoft.com/office/drawing/2014/main" id="{14D99FEB-9E79-443A-9B6C-77DCEE1A52FF}"/>
                </a:ext>
              </a:extLst>
            </p:cNvPr>
            <p:cNvSpPr/>
            <p:nvPr/>
          </p:nvSpPr>
          <p:spPr>
            <a:xfrm>
              <a:off x="9644992" y="3467304"/>
              <a:ext cx="1243280" cy="432048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Validation Metrics</a:t>
              </a:r>
              <a:endParaRPr lang="ko-KR" altLang="en-US" sz="1000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sp>
          <p:nvSpPr>
            <p:cNvPr id="27" name="사각형: 둥근 모서리 50">
              <a:extLst>
                <a:ext uri="{FF2B5EF4-FFF2-40B4-BE49-F238E27FC236}">
                  <a16:creationId xmlns:a16="http://schemas.microsoft.com/office/drawing/2014/main" id="{99B47D79-2378-43E1-9C73-E2875C2ACA44}"/>
                </a:ext>
              </a:extLst>
            </p:cNvPr>
            <p:cNvSpPr/>
            <p:nvPr/>
          </p:nvSpPr>
          <p:spPr>
            <a:xfrm>
              <a:off x="7654230" y="4199163"/>
              <a:ext cx="1193428" cy="564655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Structural </a:t>
              </a:r>
            </a:p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Annotation</a:t>
              </a:r>
              <a:endParaRPr lang="ko-KR" altLang="en-US" sz="1000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sp>
          <p:nvSpPr>
            <p:cNvPr id="28" name="사각형: 둥근 모서리 52">
              <a:extLst>
                <a:ext uri="{FF2B5EF4-FFF2-40B4-BE49-F238E27FC236}">
                  <a16:creationId xmlns:a16="http://schemas.microsoft.com/office/drawing/2014/main" id="{C33D0B71-FEFB-4162-913F-72A7531520F4}"/>
                </a:ext>
              </a:extLst>
            </p:cNvPr>
            <p:cNvSpPr/>
            <p:nvPr/>
          </p:nvSpPr>
          <p:spPr>
            <a:xfrm>
              <a:off x="5372188" y="4199163"/>
              <a:ext cx="1254216" cy="5652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Functional </a:t>
              </a:r>
            </a:p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Annotation</a:t>
              </a:r>
              <a:endParaRPr lang="ko-KR" altLang="en-US" sz="1000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cxnSp>
          <p:nvCxnSpPr>
            <p:cNvPr id="29" name="직선 화살표 연결선 54">
              <a:extLst>
                <a:ext uri="{FF2B5EF4-FFF2-40B4-BE49-F238E27FC236}">
                  <a16:creationId xmlns:a16="http://schemas.microsoft.com/office/drawing/2014/main" id="{2A7D5222-123D-4EBA-BBA5-D8B49640C6E9}"/>
                </a:ext>
              </a:extLst>
            </p:cNvPr>
            <p:cNvCxnSpPr>
              <a:stCxn id="24" idx="3"/>
              <a:endCxn id="25" idx="1"/>
            </p:cNvCxnSpPr>
            <p:nvPr/>
          </p:nvCxnSpPr>
          <p:spPr>
            <a:xfrm>
              <a:off x="6576395" y="3676518"/>
              <a:ext cx="686599" cy="681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직선 화살표 연결선 56">
              <a:extLst>
                <a:ext uri="{FF2B5EF4-FFF2-40B4-BE49-F238E27FC236}">
                  <a16:creationId xmlns:a16="http://schemas.microsoft.com/office/drawing/2014/main" id="{F24380CA-2392-4838-B781-2C9FCE78F317}"/>
                </a:ext>
              </a:extLst>
            </p:cNvPr>
            <p:cNvCxnSpPr>
              <a:stCxn id="25" idx="3"/>
              <a:endCxn id="26" idx="1"/>
            </p:cNvCxnSpPr>
            <p:nvPr/>
          </p:nvCxnSpPr>
          <p:spPr>
            <a:xfrm>
              <a:off x="9243274" y="3683328"/>
              <a:ext cx="40171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화살표 연결선 58">
              <a:extLst>
                <a:ext uri="{FF2B5EF4-FFF2-40B4-BE49-F238E27FC236}">
                  <a16:creationId xmlns:a16="http://schemas.microsoft.com/office/drawing/2014/main" id="{DA5CBA93-FC4B-48F4-8AF5-59BDC2D792FB}"/>
                </a:ext>
              </a:extLst>
            </p:cNvPr>
            <p:cNvCxnSpPr>
              <a:stCxn id="25" idx="2"/>
              <a:endCxn id="27" idx="0"/>
            </p:cNvCxnSpPr>
            <p:nvPr/>
          </p:nvCxnSpPr>
          <p:spPr>
            <a:xfrm flipH="1">
              <a:off x="8250944" y="3899352"/>
              <a:ext cx="2190" cy="29981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화살표 연결선 60">
              <a:extLst>
                <a:ext uri="{FF2B5EF4-FFF2-40B4-BE49-F238E27FC236}">
                  <a16:creationId xmlns:a16="http://schemas.microsoft.com/office/drawing/2014/main" id="{E3741984-5439-40D4-A451-10A15353F5CB}"/>
                </a:ext>
              </a:extLst>
            </p:cNvPr>
            <p:cNvCxnSpPr>
              <a:stCxn id="27" idx="1"/>
              <a:endCxn id="28" idx="3"/>
            </p:cNvCxnSpPr>
            <p:nvPr/>
          </p:nvCxnSpPr>
          <p:spPr>
            <a:xfrm flipH="1">
              <a:off x="6626404" y="4481491"/>
              <a:ext cx="1027826" cy="27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순서도: 자기 디스크 61">
              <a:extLst>
                <a:ext uri="{FF2B5EF4-FFF2-40B4-BE49-F238E27FC236}">
                  <a16:creationId xmlns:a16="http://schemas.microsoft.com/office/drawing/2014/main" id="{D98B6F56-7E17-4BAA-8AEC-3714C5C84A05}"/>
                </a:ext>
              </a:extLst>
            </p:cNvPr>
            <p:cNvSpPr/>
            <p:nvPr/>
          </p:nvSpPr>
          <p:spPr>
            <a:xfrm>
              <a:off x="9639391" y="4420963"/>
              <a:ext cx="1280146" cy="361930"/>
            </a:xfrm>
            <a:prstGeom prst="flowChartMagneticDisk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Protein (10 Genomes)</a:t>
              </a:r>
            </a:p>
          </p:txBody>
        </p:sp>
        <p:cxnSp>
          <p:nvCxnSpPr>
            <p:cNvPr id="34" name="직선 화살표 연결선 63">
              <a:extLst>
                <a:ext uri="{FF2B5EF4-FFF2-40B4-BE49-F238E27FC236}">
                  <a16:creationId xmlns:a16="http://schemas.microsoft.com/office/drawing/2014/main" id="{1ED95808-6B57-4ECD-AE5C-914BCF6AE0F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847658" y="3880834"/>
              <a:ext cx="797334" cy="3557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화살표 연결선 65">
              <a:extLst>
                <a:ext uri="{FF2B5EF4-FFF2-40B4-BE49-F238E27FC236}">
                  <a16:creationId xmlns:a16="http://schemas.microsoft.com/office/drawing/2014/main" id="{932CD77F-5D5D-44F7-938B-DD7ABAB7BEB9}"/>
                </a:ext>
              </a:extLst>
            </p:cNvPr>
            <p:cNvCxnSpPr>
              <a:endCxn id="27" idx="3"/>
            </p:cNvCxnSpPr>
            <p:nvPr/>
          </p:nvCxnSpPr>
          <p:spPr>
            <a:xfrm flipH="1">
              <a:off x="8847658" y="4475460"/>
              <a:ext cx="791733" cy="603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93C1D84-0EC9-4139-BBBF-B203C671B5D5}"/>
                </a:ext>
              </a:extLst>
            </p:cNvPr>
            <p:cNvSpPr txBox="1"/>
            <p:nvPr/>
          </p:nvSpPr>
          <p:spPr>
            <a:xfrm>
              <a:off x="6164218" y="3742106"/>
              <a:ext cx="1440160" cy="19431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b="1" dirty="0">
                  <a:latin typeface="Palatino Linotype" panose="02040502050505030304" pitchFamily="18" charset="0"/>
                  <a:ea typeface="+mn-ea"/>
                </a:rPr>
                <a:t>Repeat </a:t>
              </a:r>
            </a:p>
            <a:p>
              <a:pPr algn="ctr"/>
              <a:r>
                <a:rPr lang="en-US" altLang="ko-KR" sz="1000" b="1" dirty="0">
                  <a:latin typeface="Palatino Linotype" panose="02040502050505030304" pitchFamily="18" charset="0"/>
                  <a:ea typeface="+mn-ea"/>
                </a:rPr>
                <a:t>Masker v4.0.5</a:t>
              </a:r>
              <a:endParaRPr lang="ko-KR" altLang="en-US" sz="1000" b="1" dirty="0" err="1">
                <a:latin typeface="Palatino Linotype" panose="02040502050505030304" pitchFamily="18" charset="0"/>
                <a:ea typeface="+mn-ea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A28D5FD-3E80-4719-9B90-E7B84C7AA16B}"/>
                </a:ext>
              </a:extLst>
            </p:cNvPr>
            <p:cNvSpPr txBox="1"/>
            <p:nvPr/>
          </p:nvSpPr>
          <p:spPr>
            <a:xfrm>
              <a:off x="8724053" y="3466882"/>
              <a:ext cx="1440160" cy="19431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b="1" dirty="0">
                  <a:latin typeface="Palatino Linotype" panose="02040502050505030304" pitchFamily="18" charset="0"/>
                  <a:ea typeface="+mn-ea"/>
                </a:rPr>
                <a:t>N50</a:t>
              </a:r>
              <a:endParaRPr lang="ko-KR" altLang="en-US" sz="1000" b="1" dirty="0" err="1">
                <a:latin typeface="Palatino Linotype" panose="02040502050505030304" pitchFamily="18" charset="0"/>
                <a:ea typeface="+mn-ea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C43E3F5-8339-44D6-92E3-01F8652A042C}"/>
                </a:ext>
              </a:extLst>
            </p:cNvPr>
            <p:cNvSpPr txBox="1"/>
            <p:nvPr/>
          </p:nvSpPr>
          <p:spPr>
            <a:xfrm>
              <a:off x="8930417" y="3995170"/>
              <a:ext cx="1440160" cy="19431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b="1" dirty="0">
                  <a:latin typeface="Palatino Linotype" panose="02040502050505030304" pitchFamily="18" charset="0"/>
                  <a:ea typeface="+mn-ea"/>
                </a:rPr>
                <a:t>BUSCO v4</a:t>
              </a:r>
              <a:endParaRPr lang="ko-KR" altLang="en-US" sz="1000" b="1" dirty="0" err="1">
                <a:latin typeface="Palatino Linotype" panose="02040502050505030304" pitchFamily="18" charset="0"/>
                <a:ea typeface="+mn-ea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9C89AB1-BD60-4BAD-9D8F-A09558764776}"/>
                </a:ext>
              </a:extLst>
            </p:cNvPr>
            <p:cNvSpPr txBox="1"/>
            <p:nvPr/>
          </p:nvSpPr>
          <p:spPr>
            <a:xfrm>
              <a:off x="8551171" y="4677498"/>
              <a:ext cx="1440160" cy="19431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b="1" dirty="0">
                  <a:latin typeface="Palatino Linotype" panose="02040502050505030304" pitchFamily="18" charset="0"/>
                  <a:ea typeface="+mn-ea"/>
                </a:rPr>
                <a:t>ISG –</a:t>
              </a:r>
            </a:p>
            <a:p>
              <a:pPr algn="ctr"/>
              <a:r>
                <a:rPr lang="en-US" altLang="ko-KR" sz="1000" b="1" dirty="0">
                  <a:latin typeface="Palatino Linotype" panose="02040502050505030304" pitchFamily="18" charset="0"/>
                  <a:ea typeface="+mn-ea"/>
                </a:rPr>
                <a:t> Gene Prediction Pipeline</a:t>
              </a:r>
              <a:endParaRPr lang="ko-KR" altLang="en-US" sz="1000" b="1" dirty="0" err="1">
                <a:latin typeface="Palatino Linotype" panose="02040502050505030304" pitchFamily="18" charset="0"/>
                <a:ea typeface="+mn-ea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13E7012-BA64-4608-B62E-BFC27C572139}"/>
                </a:ext>
              </a:extLst>
            </p:cNvPr>
            <p:cNvSpPr txBox="1"/>
            <p:nvPr/>
          </p:nvSpPr>
          <p:spPr>
            <a:xfrm>
              <a:off x="6473800" y="4243168"/>
              <a:ext cx="1440160" cy="19431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b="1" dirty="0" err="1">
                  <a:latin typeface="Palatino Linotype" panose="02040502050505030304" pitchFamily="18" charset="0"/>
                  <a:ea typeface="+mn-ea"/>
                </a:rPr>
                <a:t>Trinotate</a:t>
              </a:r>
              <a:r>
                <a:rPr lang="en-US" altLang="ko-KR" sz="1000" b="1" dirty="0">
                  <a:latin typeface="Palatino Linotype" panose="02040502050505030304" pitchFamily="18" charset="0"/>
                  <a:ea typeface="+mn-ea"/>
                </a:rPr>
                <a:t> v3.0.1</a:t>
              </a:r>
              <a:endParaRPr lang="ko-KR" altLang="en-US" sz="1000" b="1" dirty="0" err="1">
                <a:solidFill>
                  <a:srgbClr val="FF0000"/>
                </a:solidFill>
                <a:latin typeface="Palatino Linotype" panose="02040502050505030304" pitchFamily="18" charset="0"/>
                <a:ea typeface="+mn-ea"/>
              </a:endParaRPr>
            </a:p>
          </p:txBody>
        </p:sp>
      </p:grpSp>
      <p:sp>
        <p:nvSpPr>
          <p:cNvPr id="41" name="사각형: 둥근 모서리 74">
            <a:extLst>
              <a:ext uri="{FF2B5EF4-FFF2-40B4-BE49-F238E27FC236}">
                <a16:creationId xmlns:a16="http://schemas.microsoft.com/office/drawing/2014/main" id="{72F5B25D-71EC-4135-9DA9-7EC9F939E017}"/>
              </a:ext>
            </a:extLst>
          </p:cNvPr>
          <p:cNvSpPr/>
          <p:nvPr/>
        </p:nvSpPr>
        <p:spPr>
          <a:xfrm>
            <a:off x="5239917" y="2992145"/>
            <a:ext cx="5824636" cy="1627793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>
              <a:lnSpc>
                <a:spcPct val="150000"/>
              </a:lnSpc>
            </a:pP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DAA120C-92F5-44F6-8F2F-E3558B1E339D}"/>
              </a:ext>
            </a:extLst>
          </p:cNvPr>
          <p:cNvSpPr txBox="1"/>
          <p:nvPr/>
        </p:nvSpPr>
        <p:spPr>
          <a:xfrm>
            <a:off x="4419186" y="3382078"/>
            <a:ext cx="1128302" cy="386114"/>
          </a:xfrm>
          <a:prstGeom prst="rect">
            <a:avLst/>
          </a:prstGeom>
          <a:noFill/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b="1" dirty="0">
                <a:latin typeface="Palatino Linotype" panose="02040502050505030304" pitchFamily="18" charset="0"/>
                <a:ea typeface="+mn-ea"/>
              </a:rPr>
              <a:t>Repeat </a:t>
            </a:r>
          </a:p>
          <a:p>
            <a:pPr algn="ctr"/>
            <a:r>
              <a:rPr lang="en-US" altLang="ko-KR" sz="1000" b="1" dirty="0">
                <a:latin typeface="Palatino Linotype" panose="02040502050505030304" pitchFamily="18" charset="0"/>
                <a:ea typeface="+mn-ea"/>
              </a:rPr>
              <a:t>Modeler v1.0.8</a:t>
            </a:r>
          </a:p>
          <a:p>
            <a:pPr algn="ctr"/>
            <a:r>
              <a:rPr lang="en-US" altLang="ko-KR" sz="1000" b="1" dirty="0" err="1">
                <a:latin typeface="Palatino Linotype" panose="02040502050505030304" pitchFamily="18" charset="0"/>
              </a:rPr>
              <a:t>RepeatScout</a:t>
            </a:r>
            <a:r>
              <a:rPr lang="en-US" altLang="ko-KR" sz="1000" b="1" dirty="0">
                <a:latin typeface="Palatino Linotype" panose="02040502050505030304" pitchFamily="18" charset="0"/>
              </a:rPr>
              <a:t> v1.0.5</a:t>
            </a:r>
            <a:endParaRPr lang="ko-KR" altLang="en-US" sz="1000" b="1" dirty="0" err="1">
              <a:latin typeface="Palatino Linotype" panose="02040502050505030304" pitchFamily="18" charset="0"/>
              <a:ea typeface="+mn-ea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B822E11-C996-4001-9326-984CD835CD50}"/>
              </a:ext>
            </a:extLst>
          </p:cNvPr>
          <p:cNvSpPr txBox="1"/>
          <p:nvPr/>
        </p:nvSpPr>
        <p:spPr>
          <a:xfrm>
            <a:off x="5460620" y="2780928"/>
            <a:ext cx="2347816" cy="246955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r>
              <a:rPr lang="en-US" altLang="ko-KR" sz="1000" b="1" dirty="0">
                <a:solidFill>
                  <a:schemeClr val="accent3">
                    <a:lumMod val="75000"/>
                  </a:schemeClr>
                </a:solidFill>
                <a:latin typeface="Palatino Linotype" panose="02040502050505030304" pitchFamily="18" charset="0"/>
                <a:ea typeface="+mn-ea"/>
              </a:rPr>
              <a:t>C. Structure and Functional Annotation</a:t>
            </a:r>
            <a:endParaRPr lang="ko-KR" altLang="en-US" sz="1000" b="1" dirty="0" err="1">
              <a:solidFill>
                <a:schemeClr val="accent3">
                  <a:lumMod val="75000"/>
                </a:schemeClr>
              </a:solidFill>
              <a:latin typeface="Palatino Linotype" panose="02040502050505030304" pitchFamily="18" charset="0"/>
              <a:ea typeface="+mn-ea"/>
            </a:endParaRPr>
          </a:p>
        </p:txBody>
      </p:sp>
      <p:grpSp>
        <p:nvGrpSpPr>
          <p:cNvPr id="44" name="Group 43"/>
          <p:cNvGrpSpPr/>
          <p:nvPr/>
        </p:nvGrpSpPr>
        <p:grpSpPr>
          <a:xfrm>
            <a:off x="3518764" y="1304428"/>
            <a:ext cx="1202269" cy="1062670"/>
            <a:chOff x="3677227" y="1304428"/>
            <a:chExt cx="1202269" cy="1062670"/>
          </a:xfrm>
        </p:grpSpPr>
        <p:sp>
          <p:nvSpPr>
            <p:cNvPr id="45" name="사각형: 둥근 모서리 12">
              <a:extLst>
                <a:ext uri="{FF2B5EF4-FFF2-40B4-BE49-F238E27FC236}">
                  <a16:creationId xmlns:a16="http://schemas.microsoft.com/office/drawing/2014/main" id="{D77ADAB8-921E-4BFF-B6C5-9D382B047C9C}"/>
                </a:ext>
              </a:extLst>
            </p:cNvPr>
            <p:cNvSpPr/>
            <p:nvPr/>
          </p:nvSpPr>
          <p:spPr>
            <a:xfrm>
              <a:off x="3677227" y="1304428"/>
              <a:ext cx="1202269" cy="1062670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 w="19050">
              <a:solidFill>
                <a:schemeClr val="accent3">
                  <a:lumMod val="75000"/>
                </a:schemeClr>
              </a:solidFill>
              <a:prstDash val="sysDot"/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lnSpc>
                  <a:spcPct val="150000"/>
                </a:lnSpc>
              </a:pPr>
              <a:endParaRPr lang="ko-KR" altLang="en-US" sz="1000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sp>
          <p:nvSpPr>
            <p:cNvPr id="46" name="순서도: 자기 디스크 8">
              <a:extLst>
                <a:ext uri="{FF2B5EF4-FFF2-40B4-BE49-F238E27FC236}">
                  <a16:creationId xmlns:a16="http://schemas.microsoft.com/office/drawing/2014/main" id="{9F573E27-D555-44A2-BE9F-1D75BA5CB5DB}"/>
                </a:ext>
              </a:extLst>
            </p:cNvPr>
            <p:cNvSpPr/>
            <p:nvPr/>
          </p:nvSpPr>
          <p:spPr>
            <a:xfrm>
              <a:off x="3799896" y="1842917"/>
              <a:ext cx="977308" cy="359851"/>
            </a:xfrm>
            <a:prstGeom prst="flowChartMagneticDisk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b="1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NCBI organelle </a:t>
              </a:r>
              <a:endParaRPr lang="ko-KR" altLang="en-US" sz="1000" b="1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sp>
          <p:nvSpPr>
            <p:cNvPr id="47" name="순서도: 자기 디스크 6">
              <a:extLst>
                <a:ext uri="{FF2B5EF4-FFF2-40B4-BE49-F238E27FC236}">
                  <a16:creationId xmlns:a16="http://schemas.microsoft.com/office/drawing/2014/main" id="{A31DA985-72F2-48FA-B986-2074E183CE43}"/>
                </a:ext>
              </a:extLst>
            </p:cNvPr>
            <p:cNvSpPr/>
            <p:nvPr/>
          </p:nvSpPr>
          <p:spPr>
            <a:xfrm>
              <a:off x="3799896" y="1418316"/>
              <a:ext cx="977308" cy="356338"/>
            </a:xfrm>
            <a:prstGeom prst="flowChartMagneticDisk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/>
              <a:r>
                <a:rPr lang="en-US" altLang="ko-KR" sz="1000" b="1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NCBI Bacteria</a:t>
              </a:r>
              <a:endParaRPr lang="ko-KR" altLang="en-US" sz="1000" b="1" dirty="0" err="1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610FB71F-059B-48C0-83F3-6671115958F9}"/>
              </a:ext>
            </a:extLst>
          </p:cNvPr>
          <p:cNvSpPr txBox="1"/>
          <p:nvPr/>
        </p:nvSpPr>
        <p:spPr>
          <a:xfrm>
            <a:off x="1657151" y="1684285"/>
            <a:ext cx="803517" cy="373410"/>
          </a:xfrm>
          <a:prstGeom prst="rect">
            <a:avLst/>
          </a:prstGeom>
          <a:noFill/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b="1" dirty="0" err="1">
                <a:latin typeface="Palatino Linotype" panose="02040502050505030304" pitchFamily="18" charset="0"/>
                <a:ea typeface="+mn-ea"/>
              </a:rPr>
              <a:t>JellyFish</a:t>
            </a:r>
            <a:endParaRPr lang="en-US" altLang="ko-KR" sz="1000" b="1" dirty="0">
              <a:latin typeface="Palatino Linotype" panose="02040502050505030304" pitchFamily="18" charset="0"/>
              <a:ea typeface="+mn-ea"/>
            </a:endParaRPr>
          </a:p>
          <a:p>
            <a:pPr algn="ctr"/>
            <a:r>
              <a:rPr lang="en-US" altLang="ko-KR" sz="1000" b="1" i="1" dirty="0">
                <a:latin typeface="Palatino Linotype" panose="02040502050505030304" pitchFamily="18" charset="0"/>
                <a:ea typeface="+mn-ea"/>
              </a:rPr>
              <a:t>k</a:t>
            </a:r>
            <a:r>
              <a:rPr lang="en-US" altLang="ko-KR" sz="1000" b="1" dirty="0">
                <a:latin typeface="Palatino Linotype" panose="02040502050505030304" pitchFamily="18" charset="0"/>
                <a:ea typeface="+mn-ea"/>
              </a:rPr>
              <a:t>-</a:t>
            </a:r>
            <a:r>
              <a:rPr lang="en-US" altLang="ko-KR" sz="1000" b="1" dirty="0" err="1">
                <a:latin typeface="Palatino Linotype" panose="02040502050505030304" pitchFamily="18" charset="0"/>
                <a:ea typeface="+mn-ea"/>
              </a:rPr>
              <a:t>mer</a:t>
            </a:r>
            <a:endParaRPr lang="ko-KR" altLang="en-US" sz="1000" b="1" dirty="0" err="1">
              <a:latin typeface="Palatino Linotype" panose="02040502050505030304" pitchFamily="18" charset="0"/>
              <a:ea typeface="+mn-ea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42066" y="6387604"/>
            <a:ext cx="11306176" cy="266278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r>
              <a:rPr lang="en-US" sz="1200" dirty="0">
                <a:latin typeface="Palatino Linotype" panose="02040502050505030304" pitchFamily="18" charset="0"/>
                <a:ea typeface="+mn-ea"/>
              </a:rPr>
              <a:t>Supplementary Figure 1: Work flow deployed and results. A-C is workflow; D: Estimated Genome Size and E : Assembly comparison between available draft and assembled genome.</a:t>
            </a:r>
          </a:p>
        </p:txBody>
      </p:sp>
      <p:cxnSp>
        <p:nvCxnSpPr>
          <p:cNvPr id="51" name="직선 화살표 연결선 47">
            <a:extLst>
              <a:ext uri="{FF2B5EF4-FFF2-40B4-BE49-F238E27FC236}">
                <a16:creationId xmlns:a16="http://schemas.microsoft.com/office/drawing/2014/main" id="{1180C388-DCD8-48E7-BD05-4086F6146102}"/>
              </a:ext>
            </a:extLst>
          </p:cNvPr>
          <p:cNvCxnSpPr>
            <a:stCxn id="25" idx="0"/>
            <a:endCxn id="54" idx="2"/>
          </p:cNvCxnSpPr>
          <p:nvPr/>
        </p:nvCxnSpPr>
        <p:spPr>
          <a:xfrm flipH="1" flipV="1">
            <a:off x="8281880" y="2021152"/>
            <a:ext cx="2190" cy="1095301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사각형: 둥근 모서리 42">
            <a:extLst>
              <a:ext uri="{FF2B5EF4-FFF2-40B4-BE49-F238E27FC236}">
                <a16:creationId xmlns:a16="http://schemas.microsoft.com/office/drawing/2014/main" id="{1D499521-2570-4F4D-B35D-63EBD6BC1437}"/>
              </a:ext>
            </a:extLst>
          </p:cNvPr>
          <p:cNvSpPr/>
          <p:nvPr/>
        </p:nvSpPr>
        <p:spPr>
          <a:xfrm>
            <a:off x="5239917" y="1057320"/>
            <a:ext cx="5824635" cy="1622984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>
              <a:lnSpc>
                <a:spcPct val="150000"/>
              </a:lnSpc>
            </a:pP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B822E11-C996-4001-9326-984CD835CD50}"/>
              </a:ext>
            </a:extLst>
          </p:cNvPr>
          <p:cNvSpPr txBox="1"/>
          <p:nvPr/>
        </p:nvSpPr>
        <p:spPr>
          <a:xfrm>
            <a:off x="5403124" y="872366"/>
            <a:ext cx="2347816" cy="246955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r>
              <a:rPr lang="en-US" altLang="ko-KR" sz="1000" b="1" dirty="0">
                <a:solidFill>
                  <a:schemeClr val="accent3">
                    <a:lumMod val="75000"/>
                  </a:schemeClr>
                </a:solidFill>
                <a:latin typeface="Palatino Linotype" panose="02040502050505030304" pitchFamily="18" charset="0"/>
              </a:rPr>
              <a:t>D</a:t>
            </a:r>
            <a:r>
              <a:rPr lang="en-US" altLang="ko-KR" sz="1000" b="1" dirty="0">
                <a:solidFill>
                  <a:schemeClr val="accent3">
                    <a:lumMod val="75000"/>
                  </a:schemeClr>
                </a:solidFill>
                <a:latin typeface="Palatino Linotype" panose="02040502050505030304" pitchFamily="18" charset="0"/>
                <a:ea typeface="+mn-ea"/>
              </a:rPr>
              <a:t>. Chromosomal level Scaffolding </a:t>
            </a:r>
            <a:endParaRPr lang="ko-KR" altLang="en-US" sz="1000" b="1" dirty="0" err="1">
              <a:solidFill>
                <a:schemeClr val="accent3">
                  <a:lumMod val="75000"/>
                </a:schemeClr>
              </a:solidFill>
              <a:latin typeface="Palatino Linotype" panose="02040502050505030304" pitchFamily="18" charset="0"/>
              <a:ea typeface="+mn-ea"/>
            </a:endParaRPr>
          </a:p>
        </p:txBody>
      </p:sp>
      <p:sp>
        <p:nvSpPr>
          <p:cNvPr id="54" name="사각형: 둥근 모서리 36">
            <a:extLst>
              <a:ext uri="{FF2B5EF4-FFF2-40B4-BE49-F238E27FC236}">
                <a16:creationId xmlns:a16="http://schemas.microsoft.com/office/drawing/2014/main" id="{CD725865-EC99-4A0F-AD87-099A7AC862EF}"/>
              </a:ext>
            </a:extLst>
          </p:cNvPr>
          <p:cNvSpPr/>
          <p:nvPr/>
        </p:nvSpPr>
        <p:spPr>
          <a:xfrm>
            <a:off x="7370286" y="1419132"/>
            <a:ext cx="1823188" cy="602020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b="0" i="0" u="none" strike="noStrike" dirty="0">
                <a:effectLst/>
                <a:latin typeface="Palatino Linotype" panose="02040502050505030304" pitchFamily="18" charset="0"/>
              </a:rPr>
              <a:t>Cucumber_9930_v3</a:t>
            </a:r>
          </a:p>
          <a:p>
            <a:pPr algn="ctr"/>
            <a:r>
              <a:rPr lang="en-US" altLang="ko-KR" sz="1000" b="0" i="0" u="none" strike="noStrike" dirty="0">
                <a:effectLst/>
                <a:latin typeface="Palatino Linotype" panose="02040502050505030304" pitchFamily="18" charset="0"/>
              </a:rPr>
              <a:t>GCF_000004075.3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93C1D84-0EC9-4139-BBBF-B203C671B5D5}"/>
              </a:ext>
            </a:extLst>
          </p:cNvPr>
          <p:cNvSpPr txBox="1"/>
          <p:nvPr/>
        </p:nvSpPr>
        <p:spPr>
          <a:xfrm>
            <a:off x="7944896" y="2224854"/>
            <a:ext cx="1440160" cy="342755"/>
          </a:xfrm>
          <a:prstGeom prst="rect">
            <a:avLst/>
          </a:prstGeom>
          <a:noFill/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b="1" dirty="0" err="1">
                <a:latin typeface="Palatino Linotype" panose="02040502050505030304" pitchFamily="18" charset="0"/>
                <a:ea typeface="+mn-ea"/>
              </a:rPr>
              <a:t>Ragoo</a:t>
            </a:r>
            <a:r>
              <a:rPr lang="en-US" altLang="ko-KR" sz="1000" b="1" dirty="0">
                <a:latin typeface="Palatino Linotype" panose="02040502050505030304" pitchFamily="18" charset="0"/>
                <a:ea typeface="+mn-ea"/>
              </a:rPr>
              <a:t> v1.1</a:t>
            </a:r>
            <a:endParaRPr lang="ko-KR" altLang="en-US" sz="1000" b="1" dirty="0" err="1">
              <a:latin typeface="Palatino Linotype" panose="02040502050505030304" pitchFamily="18" charset="0"/>
              <a:ea typeface="+mn-ea"/>
            </a:endParaRPr>
          </a:p>
        </p:txBody>
      </p:sp>
      <p:sp>
        <p:nvSpPr>
          <p:cNvPr id="56" name="사각형: 둥근 모서리 36">
            <a:extLst>
              <a:ext uri="{FF2B5EF4-FFF2-40B4-BE49-F238E27FC236}">
                <a16:creationId xmlns:a16="http://schemas.microsoft.com/office/drawing/2014/main" id="{CD725865-EC99-4A0F-AD87-099A7AC862EF}"/>
              </a:ext>
            </a:extLst>
          </p:cNvPr>
          <p:cNvSpPr/>
          <p:nvPr/>
        </p:nvSpPr>
        <p:spPr>
          <a:xfrm>
            <a:off x="5421008" y="1417579"/>
            <a:ext cx="1529622" cy="602020"/>
          </a:xfrm>
          <a:prstGeom prst="roundRect">
            <a:avLst/>
          </a:prstGeom>
          <a:ln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b="1" dirty="0">
                <a:solidFill>
                  <a:srgbClr val="0F4379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Chromosomes </a:t>
            </a:r>
          </a:p>
          <a:p>
            <a:pPr algn="ctr"/>
            <a:r>
              <a:rPr lang="en-US" altLang="ko-KR" sz="1000" b="1" dirty="0">
                <a:solidFill>
                  <a:srgbClr val="0F4379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+ </a:t>
            </a:r>
          </a:p>
          <a:p>
            <a:pPr algn="ctr"/>
            <a:r>
              <a:rPr lang="en-US" altLang="ko-KR" sz="1000" b="1" dirty="0" err="1">
                <a:solidFill>
                  <a:srgbClr val="0F4379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Contigs</a:t>
            </a:r>
            <a:endParaRPr lang="ko-KR" altLang="en-US" sz="1000" b="1" dirty="0" err="1">
              <a:solidFill>
                <a:srgbClr val="0F4379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cxnSp>
        <p:nvCxnSpPr>
          <p:cNvPr id="57" name="직선 화살표 연결선 47">
            <a:extLst>
              <a:ext uri="{FF2B5EF4-FFF2-40B4-BE49-F238E27FC236}">
                <a16:creationId xmlns:a16="http://schemas.microsoft.com/office/drawing/2014/main" id="{1180C388-DCD8-48E7-BD05-4086F6146102}"/>
              </a:ext>
            </a:extLst>
          </p:cNvPr>
          <p:cNvCxnSpPr>
            <a:stCxn id="54" idx="1"/>
            <a:endCxn id="56" idx="3"/>
          </p:cNvCxnSpPr>
          <p:nvPr/>
        </p:nvCxnSpPr>
        <p:spPr>
          <a:xfrm flipH="1" flipV="1">
            <a:off x="6950630" y="1718589"/>
            <a:ext cx="419656" cy="155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순서도: 자기 디스크 61">
            <a:extLst>
              <a:ext uri="{FF2B5EF4-FFF2-40B4-BE49-F238E27FC236}">
                <a16:creationId xmlns:a16="http://schemas.microsoft.com/office/drawing/2014/main" id="{D98B6F56-7E17-4BAA-8AEC-3714C5C84A05}"/>
              </a:ext>
            </a:extLst>
          </p:cNvPr>
          <p:cNvSpPr/>
          <p:nvPr/>
        </p:nvSpPr>
        <p:spPr>
          <a:xfrm>
            <a:off x="9670327" y="3794676"/>
            <a:ext cx="1280146" cy="361930"/>
          </a:xfrm>
          <a:prstGeom prst="flowChartMagneticDisk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RNA Seq</a:t>
            </a:r>
          </a:p>
        </p:txBody>
      </p:sp>
      <p:sp>
        <p:nvSpPr>
          <p:cNvPr id="60" name="사각형: 둥근 모서리 42">
            <a:extLst>
              <a:ext uri="{FF2B5EF4-FFF2-40B4-BE49-F238E27FC236}">
                <a16:creationId xmlns:a16="http://schemas.microsoft.com/office/drawing/2014/main" id="{1D499521-2570-4F4D-B35D-63EBD6BC1437}"/>
              </a:ext>
            </a:extLst>
          </p:cNvPr>
          <p:cNvSpPr/>
          <p:nvPr/>
        </p:nvSpPr>
        <p:spPr>
          <a:xfrm>
            <a:off x="542066" y="4851411"/>
            <a:ext cx="10589354" cy="1459929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>
              <a:lnSpc>
                <a:spcPct val="150000"/>
              </a:lnSpc>
            </a:pP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cxnSp>
        <p:nvCxnSpPr>
          <p:cNvPr id="61" name="직선 화살표 연결선 65">
            <a:extLst>
              <a:ext uri="{FF2B5EF4-FFF2-40B4-BE49-F238E27FC236}">
                <a16:creationId xmlns:a16="http://schemas.microsoft.com/office/drawing/2014/main" id="{932CD77F-5D5D-44F7-938B-DD7ABAB7BEB9}"/>
              </a:ext>
            </a:extLst>
          </p:cNvPr>
          <p:cNvCxnSpPr>
            <a:stCxn id="27" idx="2"/>
            <a:endCxn id="63" idx="0"/>
          </p:cNvCxnSpPr>
          <p:nvPr/>
        </p:nvCxnSpPr>
        <p:spPr>
          <a:xfrm flipH="1">
            <a:off x="8275495" y="4412967"/>
            <a:ext cx="6385" cy="713888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사각형: 둥근 모서리 52">
            <a:extLst>
              <a:ext uri="{FF2B5EF4-FFF2-40B4-BE49-F238E27FC236}">
                <a16:creationId xmlns:a16="http://schemas.microsoft.com/office/drawing/2014/main" id="{C33D0B71-FEFB-4162-913F-72A7531520F4}"/>
              </a:ext>
            </a:extLst>
          </p:cNvPr>
          <p:cNvSpPr/>
          <p:nvPr/>
        </p:nvSpPr>
        <p:spPr>
          <a:xfrm>
            <a:off x="7648387" y="5126855"/>
            <a:ext cx="1254216" cy="426956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Orthologous Analysis</a:t>
            </a: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64" name="사각형: 둥근 모서리 52">
            <a:extLst>
              <a:ext uri="{FF2B5EF4-FFF2-40B4-BE49-F238E27FC236}">
                <a16:creationId xmlns:a16="http://schemas.microsoft.com/office/drawing/2014/main" id="{C33D0B71-FEFB-4162-913F-72A7531520F4}"/>
              </a:ext>
            </a:extLst>
          </p:cNvPr>
          <p:cNvSpPr/>
          <p:nvPr/>
        </p:nvSpPr>
        <p:spPr>
          <a:xfrm>
            <a:off x="5460620" y="5174164"/>
            <a:ext cx="1254216" cy="332337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Gain/Loss</a:t>
            </a: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cxnSp>
        <p:nvCxnSpPr>
          <p:cNvPr id="65" name="직선 화살표 연결선 65">
            <a:extLst>
              <a:ext uri="{FF2B5EF4-FFF2-40B4-BE49-F238E27FC236}">
                <a16:creationId xmlns:a16="http://schemas.microsoft.com/office/drawing/2014/main" id="{932CD77F-5D5D-44F7-938B-DD7ABAB7BEB9}"/>
              </a:ext>
            </a:extLst>
          </p:cNvPr>
          <p:cNvCxnSpPr>
            <a:stCxn id="63" idx="1"/>
            <a:endCxn id="64" idx="3"/>
          </p:cNvCxnSpPr>
          <p:nvPr/>
        </p:nvCxnSpPr>
        <p:spPr>
          <a:xfrm flipH="1">
            <a:off x="6714836" y="5340333"/>
            <a:ext cx="933551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화살표 연결선 65">
            <a:extLst>
              <a:ext uri="{FF2B5EF4-FFF2-40B4-BE49-F238E27FC236}">
                <a16:creationId xmlns:a16="http://schemas.microsoft.com/office/drawing/2014/main" id="{932CD77F-5D5D-44F7-938B-DD7ABAB7BEB9}"/>
              </a:ext>
            </a:extLst>
          </p:cNvPr>
          <p:cNvCxnSpPr>
            <a:endCxn id="63" idx="0"/>
          </p:cNvCxnSpPr>
          <p:nvPr/>
        </p:nvCxnSpPr>
        <p:spPr>
          <a:xfrm flipH="1">
            <a:off x="8275495" y="4124609"/>
            <a:ext cx="1391338" cy="1002246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2B822E11-C996-4001-9326-984CD835CD50}"/>
              </a:ext>
            </a:extLst>
          </p:cNvPr>
          <p:cNvSpPr txBox="1"/>
          <p:nvPr/>
        </p:nvSpPr>
        <p:spPr>
          <a:xfrm>
            <a:off x="684397" y="4680955"/>
            <a:ext cx="2347816" cy="246955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r>
              <a:rPr lang="en-US" altLang="ko-KR" sz="1000" b="1" dirty="0">
                <a:solidFill>
                  <a:schemeClr val="accent3">
                    <a:lumMod val="75000"/>
                  </a:schemeClr>
                </a:solidFill>
                <a:latin typeface="Palatino Linotype" panose="02040502050505030304" pitchFamily="18" charset="0"/>
              </a:rPr>
              <a:t>E</a:t>
            </a:r>
            <a:r>
              <a:rPr lang="en-US" altLang="ko-KR" sz="1000" b="1" dirty="0">
                <a:solidFill>
                  <a:schemeClr val="accent3">
                    <a:lumMod val="75000"/>
                  </a:schemeClr>
                </a:solidFill>
                <a:latin typeface="Palatino Linotype" panose="02040502050505030304" pitchFamily="18" charset="0"/>
                <a:ea typeface="+mn-ea"/>
              </a:rPr>
              <a:t>. Comparative analysis workflow </a:t>
            </a:r>
            <a:endParaRPr lang="ko-KR" altLang="en-US" sz="1000" b="1" dirty="0" err="1">
              <a:solidFill>
                <a:schemeClr val="accent3">
                  <a:lumMod val="75000"/>
                </a:schemeClr>
              </a:solidFill>
              <a:latin typeface="Palatino Linotype" panose="02040502050505030304" pitchFamily="18" charset="0"/>
              <a:ea typeface="+mn-ea"/>
            </a:endParaRPr>
          </a:p>
        </p:txBody>
      </p:sp>
      <p:sp>
        <p:nvSpPr>
          <p:cNvPr id="73" name="사각형: 둥근 모서리 52">
            <a:extLst>
              <a:ext uri="{FF2B5EF4-FFF2-40B4-BE49-F238E27FC236}">
                <a16:creationId xmlns:a16="http://schemas.microsoft.com/office/drawing/2014/main" id="{C33D0B71-FEFB-4162-913F-72A7531520F4}"/>
              </a:ext>
            </a:extLst>
          </p:cNvPr>
          <p:cNvSpPr/>
          <p:nvPr/>
        </p:nvSpPr>
        <p:spPr>
          <a:xfrm>
            <a:off x="7648387" y="5927712"/>
            <a:ext cx="1254216" cy="258155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Orthologs containing </a:t>
            </a:r>
          </a:p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all the species</a:t>
            </a:r>
          </a:p>
        </p:txBody>
      </p:sp>
      <p:cxnSp>
        <p:nvCxnSpPr>
          <p:cNvPr id="74" name="직선 화살표 연결선 65">
            <a:extLst>
              <a:ext uri="{FF2B5EF4-FFF2-40B4-BE49-F238E27FC236}">
                <a16:creationId xmlns:a16="http://schemas.microsoft.com/office/drawing/2014/main" id="{932CD77F-5D5D-44F7-938B-DD7ABAB7BEB9}"/>
              </a:ext>
            </a:extLst>
          </p:cNvPr>
          <p:cNvCxnSpPr>
            <a:stCxn id="63" idx="2"/>
            <a:endCxn id="73" idx="0"/>
          </p:cNvCxnSpPr>
          <p:nvPr/>
        </p:nvCxnSpPr>
        <p:spPr>
          <a:xfrm>
            <a:off x="8275495" y="5553811"/>
            <a:ext cx="0" cy="373901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사각형: 둥근 모서리 52">
            <a:extLst>
              <a:ext uri="{FF2B5EF4-FFF2-40B4-BE49-F238E27FC236}">
                <a16:creationId xmlns:a16="http://schemas.microsoft.com/office/drawing/2014/main" id="{C33D0B71-FEFB-4162-913F-72A7531520F4}"/>
              </a:ext>
            </a:extLst>
          </p:cNvPr>
          <p:cNvSpPr/>
          <p:nvPr/>
        </p:nvSpPr>
        <p:spPr>
          <a:xfrm>
            <a:off x="5453509" y="5864426"/>
            <a:ext cx="1254216" cy="377918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Relationship </a:t>
            </a:r>
          </a:p>
          <a:p>
            <a:pPr algn="ctr"/>
            <a:r>
              <a:rPr lang="en-US" altLang="ko-KR" sz="10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rPr>
              <a:t>Phylogenetic Tree</a:t>
            </a:r>
            <a:endParaRPr lang="ko-KR" altLang="en-US" sz="1000" dirty="0" err="1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cxnSp>
        <p:nvCxnSpPr>
          <p:cNvPr id="79" name="직선 화살표 연결선 65">
            <a:extLst>
              <a:ext uri="{FF2B5EF4-FFF2-40B4-BE49-F238E27FC236}">
                <a16:creationId xmlns:a16="http://schemas.microsoft.com/office/drawing/2014/main" id="{932CD77F-5D5D-44F7-938B-DD7ABAB7BEB9}"/>
              </a:ext>
            </a:extLst>
          </p:cNvPr>
          <p:cNvCxnSpPr>
            <a:stCxn id="73" idx="1"/>
            <a:endCxn id="78" idx="3"/>
          </p:cNvCxnSpPr>
          <p:nvPr/>
        </p:nvCxnSpPr>
        <p:spPr>
          <a:xfrm flipH="1" flipV="1">
            <a:off x="6707725" y="6053385"/>
            <a:ext cx="940662" cy="340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Rectangle 85"/>
          <p:cNvSpPr/>
          <p:nvPr/>
        </p:nvSpPr>
        <p:spPr>
          <a:xfrm>
            <a:off x="6714837" y="5065718"/>
            <a:ext cx="91245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</a:rPr>
              <a:t>CAFÉ v4.2</a:t>
            </a:r>
            <a:endParaRPr lang="en-US" sz="1000" dirty="0"/>
          </a:p>
        </p:txBody>
      </p:sp>
      <p:sp>
        <p:nvSpPr>
          <p:cNvPr id="93" name="Rectangle 92"/>
          <p:cNvSpPr/>
          <p:nvPr/>
        </p:nvSpPr>
        <p:spPr>
          <a:xfrm>
            <a:off x="6657340" y="5531160"/>
            <a:ext cx="110307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</a:rPr>
              <a:t>MAFFT v7.305b</a:t>
            </a:r>
          </a:p>
          <a:p>
            <a:r>
              <a:rPr lang="en-US" sz="1000" b="1" dirty="0" err="1">
                <a:solidFill>
                  <a:srgbClr val="000000"/>
                </a:solidFill>
                <a:latin typeface="Palatino Linotype" panose="02040502050505030304" pitchFamily="18" charset="0"/>
              </a:rPr>
              <a:t>Gblocks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</a:rPr>
              <a:t> v0.91b</a:t>
            </a:r>
          </a:p>
          <a:p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</a:rPr>
              <a:t>IQTREE v1.6.8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9267267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-1" y="6512356"/>
            <a:ext cx="10189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Supplementary Figure 2: Preprocessed and  Reference mapping summaries  </a:t>
            </a:r>
          </a:p>
        </p:txBody>
      </p:sp>
      <p:graphicFrame>
        <p:nvGraphicFramePr>
          <p:cNvPr id="11" name="차트 10">
            <a:extLst>
              <a:ext uri="{FF2B5EF4-FFF2-40B4-BE49-F238E27FC236}">
                <a16:creationId xmlns:a16="http://schemas.microsoft.com/office/drawing/2014/main" id="{43A91AFA-69AE-4C90-A300-3CD7C672E1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6391699"/>
              </p:ext>
            </p:extLst>
          </p:nvPr>
        </p:nvGraphicFramePr>
        <p:xfrm>
          <a:off x="1037477" y="611094"/>
          <a:ext cx="1014690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차트 11">
            <a:extLst>
              <a:ext uri="{FF2B5EF4-FFF2-40B4-BE49-F238E27FC236}">
                <a16:creationId xmlns:a16="http://schemas.microsoft.com/office/drawing/2014/main" id="{1D5F3939-4BD7-4D11-944A-34AE0AB636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3983739"/>
              </p:ext>
            </p:extLst>
          </p:nvPr>
        </p:nvGraphicFramePr>
        <p:xfrm>
          <a:off x="1037477" y="3769156"/>
          <a:ext cx="1014690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6573898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3809" y="5692431"/>
            <a:ext cx="1149531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Supplementary Figure 3: Summaries of repeat region predicted in the selected </a:t>
            </a:r>
            <a:r>
              <a:rPr lang="en-US" dirty="0" smtClean="0">
                <a:latin typeface="Palatino Linotype" panose="02040502050505030304" pitchFamily="18" charset="0"/>
              </a:rPr>
              <a:t>genomes</a:t>
            </a:r>
            <a:r>
              <a:rPr lang="en-US" dirty="0">
                <a:latin typeface="Palatino Linotype" panose="02040502050505030304" pitchFamily="18" charset="0"/>
              </a:rPr>
              <a:t>. Long interspersed nuclear </a:t>
            </a:r>
            <a:r>
              <a:rPr lang="en-US" dirty="0" smtClean="0">
                <a:latin typeface="Palatino Linotype" panose="02040502050505030304" pitchFamily="18" charset="0"/>
              </a:rPr>
              <a:t>element </a:t>
            </a:r>
            <a:r>
              <a:rPr lang="en-US" dirty="0">
                <a:latin typeface="Palatino Linotype" panose="02040502050505030304" pitchFamily="18" charset="0"/>
              </a:rPr>
              <a:t>(</a:t>
            </a:r>
            <a:r>
              <a:rPr lang="en-US" dirty="0" smtClean="0">
                <a:latin typeface="Palatino Linotype" panose="02040502050505030304" pitchFamily="18" charset="0"/>
              </a:rPr>
              <a:t>LINE</a:t>
            </a:r>
            <a:r>
              <a:rPr lang="en-US" dirty="0">
                <a:latin typeface="Palatino Linotype" panose="02040502050505030304" pitchFamily="18" charset="0"/>
              </a:rPr>
              <a:t>), Deoxyribonucleic </a:t>
            </a:r>
            <a:r>
              <a:rPr lang="en-US" dirty="0" smtClean="0">
                <a:latin typeface="Palatino Linotype" panose="02040502050505030304" pitchFamily="18" charset="0"/>
              </a:rPr>
              <a:t>acid element (DNA), </a:t>
            </a:r>
            <a:r>
              <a:rPr lang="en-US" dirty="0">
                <a:latin typeface="Palatino Linotype" panose="02040502050505030304" pitchFamily="18" charset="0"/>
              </a:rPr>
              <a:t>Short interspersed nuclear </a:t>
            </a:r>
            <a:r>
              <a:rPr lang="en-US" dirty="0" smtClean="0">
                <a:latin typeface="Palatino Linotype" panose="02040502050505030304" pitchFamily="18" charset="0"/>
              </a:rPr>
              <a:t>element </a:t>
            </a:r>
            <a:r>
              <a:rPr lang="en-US" dirty="0">
                <a:latin typeface="Palatino Linotype" panose="02040502050505030304" pitchFamily="18" charset="0"/>
              </a:rPr>
              <a:t>(SINE), long terminal repeat (LTR</a:t>
            </a:r>
            <a:r>
              <a:rPr lang="en-US" dirty="0" smtClean="0">
                <a:latin typeface="Palatino Linotype" panose="02040502050505030304" pitchFamily="18" charset="0"/>
              </a:rPr>
              <a:t>), Unclassified Repeats (Unknown</a:t>
            </a:r>
            <a:r>
              <a:rPr lang="en-US" dirty="0">
                <a:latin typeface="Palatino Linotype" panose="02040502050505030304" pitchFamily="18" charset="0"/>
              </a:rPr>
              <a:t>), </a:t>
            </a:r>
            <a:r>
              <a:rPr lang="en-US" dirty="0" smtClean="0">
                <a:latin typeface="Palatino Linotype" panose="02040502050505030304" pitchFamily="18" charset="0"/>
              </a:rPr>
              <a:t>and Rolling Circle (</a:t>
            </a:r>
            <a:r>
              <a:rPr lang="en-US" dirty="0">
                <a:latin typeface="Palatino Linotype" panose="02040502050505030304" pitchFamily="18" charset="0"/>
              </a:rPr>
              <a:t>RC</a:t>
            </a:r>
            <a:r>
              <a:rPr lang="en-US" dirty="0" smtClean="0">
                <a:latin typeface="Palatino Linotype" panose="02040502050505030304" pitchFamily="18" charset="0"/>
              </a:rPr>
              <a:t>)</a:t>
            </a:r>
            <a:endParaRPr lang="en-US" dirty="0">
              <a:latin typeface="Palatino Linotype" panose="02040502050505030304" pitchFamily="18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8923A8DF-EB4E-4FB6-9069-1AE34A85AF1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3709" y="318321"/>
            <a:ext cx="7784780" cy="51898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0939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18">
            <a:extLst>
              <a:ext uri="{FF2B5EF4-FFF2-40B4-BE49-F238E27FC236}">
                <a16:creationId xmlns:a16="http://schemas.microsoft.com/office/drawing/2014/main" id="{891E77AD-C143-4EA8-AF6B-20F9AF157EE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6847" y="564955"/>
            <a:ext cx="4936847" cy="4936847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0" y="6055156"/>
            <a:ext cx="119618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Supplementary Figure 4: Summary of </a:t>
            </a:r>
            <a:r>
              <a:rPr lang="en-US" dirty="0" err="1">
                <a:latin typeface="Palatino Linotype" panose="02040502050505030304" pitchFamily="18" charset="0"/>
              </a:rPr>
              <a:t>othologus</a:t>
            </a:r>
            <a:r>
              <a:rPr lang="en-US" dirty="0">
                <a:latin typeface="Palatino Linotype" panose="02040502050505030304" pitchFamily="18" charset="0"/>
              </a:rPr>
              <a:t>; A: Genomes used in the </a:t>
            </a:r>
            <a:r>
              <a:rPr lang="en-US" dirty="0" err="1">
                <a:latin typeface="Palatino Linotype" panose="02040502050505030304" pitchFamily="18" charset="0"/>
              </a:rPr>
              <a:t>othologus</a:t>
            </a:r>
            <a:r>
              <a:rPr lang="en-US" dirty="0">
                <a:latin typeface="Palatino Linotype" panose="02040502050505030304" pitchFamily="18" charset="0"/>
              </a:rPr>
              <a:t> analysis and B: Orthologues genes present in cucumber genomes  </a:t>
            </a:r>
          </a:p>
        </p:txBody>
      </p:sp>
      <p:pic>
        <p:nvPicPr>
          <p:cNvPr id="29" name="그림 3">
            <a:extLst>
              <a:ext uri="{FF2B5EF4-FFF2-40B4-BE49-F238E27FC236}">
                <a16:creationId xmlns:a16="http://schemas.microsoft.com/office/drawing/2014/main" id="{773AA63B-6635-4E7A-A37B-45B149872FC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157" y="1486281"/>
            <a:ext cx="6226690" cy="3736013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17D1C429-8DA6-4652-B30A-4D3EB40651F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7340" y="611087"/>
            <a:ext cx="548640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33919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31351" y="5889915"/>
            <a:ext cx="113722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Supplementary Figure 5: Tissue specific </a:t>
            </a:r>
            <a:r>
              <a:rPr lang="en-US" dirty="0" smtClean="0">
                <a:latin typeface="Palatino Linotype" panose="02040502050505030304" pitchFamily="18" charset="0"/>
              </a:rPr>
              <a:t>genes; A: </a:t>
            </a:r>
            <a:r>
              <a:rPr lang="en-US" dirty="0" err="1" smtClean="0">
                <a:latin typeface="Palatino Linotype" panose="02040502050505030304" pitchFamily="18" charset="0"/>
              </a:rPr>
              <a:t>Cucumis</a:t>
            </a:r>
            <a:r>
              <a:rPr lang="en-US" dirty="0" smtClean="0">
                <a:latin typeface="Palatino Linotype" panose="02040502050505030304" pitchFamily="18" charset="0"/>
              </a:rPr>
              <a:t> plant line cycle along with sampling</a:t>
            </a:r>
            <a:r>
              <a:rPr lang="en-US" dirty="0" smtClean="0">
                <a:latin typeface="Palatino Linotype" panose="02040502050505030304" pitchFamily="18" charset="0"/>
              </a:rPr>
              <a:t> points. B: Tissue specific gene expression. </a:t>
            </a:r>
            <a:r>
              <a:rPr lang="en-US" dirty="0" smtClean="0">
                <a:latin typeface="Palatino Linotype" panose="02040502050505030304" pitchFamily="18" charset="0"/>
              </a:rPr>
              <a:t> </a:t>
            </a:r>
            <a:endParaRPr lang="en-US" dirty="0">
              <a:latin typeface="Palatino Linotype" panose="02040502050505030304" pitchFamily="18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727D6A4C-A0D1-46E0-A122-DA578F7CAF2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0912" y="824637"/>
            <a:ext cx="6400813" cy="4572009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71021" y="391839"/>
            <a:ext cx="5557422" cy="4792721"/>
            <a:chOff x="1643754" y="659986"/>
            <a:chExt cx="7012507" cy="6149483"/>
          </a:xfrm>
        </p:grpSpPr>
        <p:grpSp>
          <p:nvGrpSpPr>
            <p:cNvPr id="6" name="Group 5"/>
            <p:cNvGrpSpPr/>
            <p:nvPr/>
          </p:nvGrpSpPr>
          <p:grpSpPr>
            <a:xfrm>
              <a:off x="2346497" y="659986"/>
              <a:ext cx="5792919" cy="6149483"/>
              <a:chOff x="2346497" y="659986"/>
              <a:chExt cx="5792919" cy="6149483"/>
            </a:xfrm>
          </p:grpSpPr>
          <p:pic>
            <p:nvPicPr>
              <p:cNvPr id="25" name="Picture 2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025008" y="4933044"/>
                <a:ext cx="1390650" cy="1876425"/>
              </a:xfrm>
              <a:prstGeom prst="rect">
                <a:avLst/>
              </a:prstGeom>
            </p:spPr>
          </p:pic>
          <p:grpSp>
            <p:nvGrpSpPr>
              <p:cNvPr id="26" name="Group 25"/>
              <p:cNvGrpSpPr/>
              <p:nvPr/>
            </p:nvGrpSpPr>
            <p:grpSpPr>
              <a:xfrm>
                <a:off x="2346497" y="659986"/>
                <a:ext cx="5792919" cy="5572965"/>
                <a:chOff x="2346497" y="659986"/>
                <a:chExt cx="5792919" cy="5572965"/>
              </a:xfrm>
            </p:grpSpPr>
            <p:pic>
              <p:nvPicPr>
                <p:cNvPr id="27" name="Picture 26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ackgroundRemoval t="10000" b="90000" l="10000" r="9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295030" y="5871001"/>
                  <a:ext cx="504825" cy="361950"/>
                </a:xfrm>
                <a:prstGeom prst="rect">
                  <a:avLst/>
                </a:prstGeom>
              </p:spPr>
            </p:pic>
            <p:pic>
              <p:nvPicPr>
                <p:cNvPr id="28" name="Picture 27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ackgroundRemoval t="0" b="100000" l="0" r="10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75044" y="5385482"/>
                  <a:ext cx="666750" cy="485775"/>
                </a:xfrm>
                <a:prstGeom prst="rect">
                  <a:avLst/>
                </a:prstGeom>
              </p:spPr>
            </p:pic>
            <p:pic>
              <p:nvPicPr>
                <p:cNvPr id="29" name="Picture 28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2798934" y="4623644"/>
                  <a:ext cx="476250" cy="1038225"/>
                </a:xfrm>
                <a:prstGeom prst="rect">
                  <a:avLst/>
                </a:prstGeom>
              </p:spPr>
            </p:pic>
            <p:pic>
              <p:nvPicPr>
                <p:cNvPr id="30" name="Picture 29"/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ackgroundRemoval t="0" b="100000" l="0" r="10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46497" y="3749559"/>
                  <a:ext cx="904875" cy="590550"/>
                </a:xfrm>
                <a:prstGeom prst="rect">
                  <a:avLst/>
                </a:prstGeom>
              </p:spPr>
            </p:pic>
            <p:pic>
              <p:nvPicPr>
                <p:cNvPr id="31" name="Picture 30"/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sharpenSoften amount="50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46497" y="2647355"/>
                  <a:ext cx="1143000" cy="876300"/>
                </a:xfrm>
                <a:prstGeom prst="rect">
                  <a:avLst/>
                </a:prstGeom>
              </p:spPr>
            </p:pic>
            <p:pic>
              <p:nvPicPr>
                <p:cNvPr id="32" name="Picture 31"/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982730" y="1354651"/>
                  <a:ext cx="981075" cy="1504950"/>
                </a:xfrm>
                <a:prstGeom prst="rect">
                  <a:avLst/>
                </a:prstGeom>
              </p:spPr>
            </p:pic>
            <p:pic>
              <p:nvPicPr>
                <p:cNvPr id="33" name="Picture 32"/>
                <p:cNvPicPr>
                  <a:picLocks noChangeAspect="1"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4080718" y="659986"/>
                  <a:ext cx="1438275" cy="1714500"/>
                </a:xfrm>
                <a:prstGeom prst="rect">
                  <a:avLst/>
                </a:prstGeom>
              </p:spPr>
            </p:pic>
            <p:pic>
              <p:nvPicPr>
                <p:cNvPr id="34" name="Picture 33"/>
                <p:cNvPicPr>
                  <a:picLocks noChangeAspect="1"/>
                </p:cNvPicPr>
                <p:nvPr/>
              </p:nvPicPr>
              <p:blipFill>
                <a:blip r:embed="rId16"/>
                <a:stretch>
                  <a:fillRect/>
                </a:stretch>
              </p:blipFill>
              <p:spPr>
                <a:xfrm>
                  <a:off x="5518993" y="704488"/>
                  <a:ext cx="1447800" cy="1962150"/>
                </a:xfrm>
                <a:prstGeom prst="rect">
                  <a:avLst/>
                </a:prstGeom>
              </p:spPr>
            </p:pic>
            <p:pic>
              <p:nvPicPr>
                <p:cNvPr id="35" name="Picture 34"/>
                <p:cNvPicPr>
                  <a:picLocks noChangeAspect="1"/>
                </p:cNvPicPr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 rot="638877">
                  <a:off x="6729716" y="1892814"/>
                  <a:ext cx="1409700" cy="1933575"/>
                </a:xfrm>
                <a:prstGeom prst="rect">
                  <a:avLst/>
                </a:prstGeom>
              </p:spPr>
            </p:pic>
            <p:pic>
              <p:nvPicPr>
                <p:cNvPr id="36" name="Picture 35"/>
                <p:cNvPicPr>
                  <a:picLocks noChangeAspect="1"/>
                </p:cNvPicPr>
                <p:nvPr/>
              </p:nvPicPr>
              <p:blipFill>
                <a:blip r:embed="rId18"/>
                <a:stretch>
                  <a:fillRect/>
                </a:stretch>
              </p:blipFill>
              <p:spPr>
                <a:xfrm rot="21255740">
                  <a:off x="6336205" y="3856844"/>
                  <a:ext cx="1524000" cy="1943100"/>
                </a:xfrm>
                <a:prstGeom prst="rect">
                  <a:avLst/>
                </a:prstGeom>
              </p:spPr>
            </p:pic>
          </p:grpSp>
        </p:grpSp>
        <p:sp>
          <p:nvSpPr>
            <p:cNvPr id="8" name="Freeform 7"/>
            <p:cNvSpPr/>
            <p:nvPr/>
          </p:nvSpPr>
          <p:spPr>
            <a:xfrm>
              <a:off x="3994951" y="5797118"/>
              <a:ext cx="319597" cy="168676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5400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Freeform 8"/>
            <p:cNvSpPr/>
            <p:nvPr/>
          </p:nvSpPr>
          <p:spPr>
            <a:xfrm>
              <a:off x="3131786" y="5171116"/>
              <a:ext cx="319597" cy="168676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5400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Freeform 9"/>
            <p:cNvSpPr/>
            <p:nvPr/>
          </p:nvSpPr>
          <p:spPr>
            <a:xfrm rot="3118225">
              <a:off x="2717462" y="4425071"/>
              <a:ext cx="319597" cy="168676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2225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Freeform 10"/>
            <p:cNvSpPr/>
            <p:nvPr/>
          </p:nvSpPr>
          <p:spPr>
            <a:xfrm rot="4852926">
              <a:off x="2646808" y="3626752"/>
              <a:ext cx="295859" cy="108987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2225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Freeform 11"/>
            <p:cNvSpPr/>
            <p:nvPr/>
          </p:nvSpPr>
          <p:spPr>
            <a:xfrm rot="5400000">
              <a:off x="2996191" y="2786115"/>
              <a:ext cx="271189" cy="222914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2225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Freeform 12"/>
            <p:cNvSpPr/>
            <p:nvPr/>
          </p:nvSpPr>
          <p:spPr>
            <a:xfrm rot="6613751">
              <a:off x="3786849" y="1521802"/>
              <a:ext cx="293901" cy="327521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2225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Freeform 13"/>
            <p:cNvSpPr/>
            <p:nvPr/>
          </p:nvSpPr>
          <p:spPr>
            <a:xfrm rot="9006044">
              <a:off x="5429594" y="1477666"/>
              <a:ext cx="293901" cy="327521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2225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Freeform 14"/>
            <p:cNvSpPr/>
            <p:nvPr/>
          </p:nvSpPr>
          <p:spPr>
            <a:xfrm rot="11433941">
              <a:off x="6762292" y="2268379"/>
              <a:ext cx="293901" cy="327521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2225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Freeform 15"/>
            <p:cNvSpPr/>
            <p:nvPr/>
          </p:nvSpPr>
          <p:spPr>
            <a:xfrm rot="13420162">
              <a:off x="7287614" y="3906476"/>
              <a:ext cx="293901" cy="327521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2225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Freeform 16"/>
            <p:cNvSpPr/>
            <p:nvPr/>
          </p:nvSpPr>
          <p:spPr>
            <a:xfrm rot="16200000">
              <a:off x="6499556" y="5683433"/>
              <a:ext cx="293901" cy="327521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2225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Freeform 17"/>
            <p:cNvSpPr/>
            <p:nvPr/>
          </p:nvSpPr>
          <p:spPr>
            <a:xfrm rot="19066472">
              <a:off x="4847817" y="6038129"/>
              <a:ext cx="176891" cy="292170"/>
            </a:xfrm>
            <a:custGeom>
              <a:avLst/>
              <a:gdLst>
                <a:gd name="connsiteX0" fmla="*/ 319597 w 319597"/>
                <a:gd name="connsiteY0" fmla="*/ 168676 h 168676"/>
                <a:gd name="connsiteX1" fmla="*/ 0 w 319597"/>
                <a:gd name="connsiteY1" fmla="*/ 0 h 168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597" h="168676">
                  <a:moveTo>
                    <a:pt x="319597" y="168676"/>
                  </a:moveTo>
                  <a:cubicBezTo>
                    <a:pt x="191610" y="97654"/>
                    <a:pt x="63623" y="26633"/>
                    <a:pt x="0" y="0"/>
                  </a:cubicBezTo>
                </a:path>
              </a:pathLst>
            </a:custGeom>
            <a:noFill/>
            <a:ln w="25400">
              <a:solidFill>
                <a:srgbClr val="002060"/>
              </a:solidFill>
              <a:headEnd type="none"/>
              <a:tailEnd type="arrow"/>
            </a:ln>
          </p:spPr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515775" y="1438720"/>
              <a:ext cx="14401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Mature </a:t>
              </a:r>
            </a:p>
            <a:p>
              <a:pPr algn="l"/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Leaf</a:t>
              </a:r>
              <a:endParaRPr lang="en-US" sz="1200" b="1" dirty="0" smtClean="0">
                <a:solidFill>
                  <a:srgbClr val="FF0000"/>
                </a:solidFill>
                <a:latin typeface="Palatino Linotype" panose="02040502050505030304" pitchFamily="18" charset="0"/>
                <a:ea typeface="+mn-ea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776277" y="2794325"/>
              <a:ext cx="936104" cy="28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1.5 </a:t>
              </a:r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Leaf</a:t>
              </a:r>
              <a:endParaRPr lang="en-US" sz="1200" b="1" dirty="0" smtClean="0">
                <a:solidFill>
                  <a:srgbClr val="FF0000"/>
                </a:solidFill>
                <a:latin typeface="Palatino Linotype" panose="02040502050505030304" pitchFamily="18" charset="0"/>
                <a:ea typeface="+mn-ea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643754" y="3911001"/>
              <a:ext cx="95333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Young </a:t>
              </a:r>
            </a:p>
            <a:p>
              <a:pPr algn="l"/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Cotyledon</a:t>
              </a:r>
              <a:endParaRPr lang="en-US" sz="1200" b="1" dirty="0" smtClean="0">
                <a:solidFill>
                  <a:srgbClr val="FF0000"/>
                </a:solidFill>
                <a:latin typeface="Palatino Linotype" panose="02040502050505030304" pitchFamily="18" charset="0"/>
                <a:ea typeface="+mn-ea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079984" y="4849054"/>
              <a:ext cx="1728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Young </a:t>
              </a:r>
            </a:p>
            <a:p>
              <a:pPr algn="l"/>
              <a:r>
                <a:rPr lang="en-US" sz="1200" b="1" dirty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S</a:t>
              </a:r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eedling</a:t>
              </a:r>
              <a:endParaRPr lang="en-US" sz="1200" b="1" dirty="0" smtClean="0">
                <a:solidFill>
                  <a:srgbClr val="FF0000"/>
                </a:solidFill>
                <a:latin typeface="Palatino Linotype" panose="02040502050505030304" pitchFamily="18" charset="0"/>
                <a:ea typeface="+mn-ea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928069" y="1685562"/>
              <a:ext cx="172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Flower</a:t>
              </a:r>
              <a:endParaRPr lang="en-US" sz="1200" b="1" dirty="0" smtClean="0">
                <a:solidFill>
                  <a:srgbClr val="FF0000"/>
                </a:solidFill>
                <a:latin typeface="Palatino Linotype" panose="02040502050505030304" pitchFamily="18" charset="0"/>
                <a:ea typeface="+mn-ea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653936" y="4956927"/>
              <a:ext cx="1002325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Palatino Linotype" panose="02040502050505030304" pitchFamily="18" charset="0"/>
                </a:rPr>
                <a:t>Fruit </a:t>
              </a:r>
              <a:endParaRPr lang="en-US" sz="1200" b="1" dirty="0" smtClean="0">
                <a:solidFill>
                  <a:srgbClr val="FF0000"/>
                </a:solidFill>
                <a:latin typeface="Palatino Linotype" panose="02040502050505030304" pitchFamily="18" charset="0"/>
                <a:ea typeface="+mn-ea"/>
              </a:endParaRPr>
            </a:p>
            <a:p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  <a:ea typeface="+mn-ea"/>
                </a:rPr>
                <a:t>Stem, </a:t>
              </a:r>
            </a:p>
            <a:p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</a:rPr>
                <a:t>And, </a:t>
              </a:r>
            </a:p>
            <a:p>
              <a:r>
                <a:rPr lang="en-US" sz="1200" b="1" dirty="0" smtClean="0">
                  <a:solidFill>
                    <a:srgbClr val="FF0000"/>
                  </a:solidFill>
                  <a:latin typeface="Palatino Linotype" panose="02040502050505030304" pitchFamily="18" charset="0"/>
                </a:rPr>
                <a:t>Root</a:t>
              </a:r>
              <a:endParaRPr lang="en-US" sz="1200" b="1" dirty="0">
                <a:solidFill>
                  <a:srgbClr val="FF0000"/>
                </a:solidFill>
                <a:latin typeface="Palatino Linotype" panose="02040502050505030304" pitchFamily="18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331351" y="417439"/>
            <a:ext cx="664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Palatino Linotype" panose="02040502050505030304" pitchFamily="18" charset="0"/>
              </a:rPr>
              <a:t>A.</a:t>
            </a:r>
            <a:endParaRPr lang="en-US" dirty="0">
              <a:latin typeface="Palatino Linotype" panose="0204050205050503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429373" y="602105"/>
            <a:ext cx="664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B</a:t>
            </a:r>
            <a:r>
              <a:rPr lang="en-US" dirty="0" smtClean="0">
                <a:latin typeface="Palatino Linotype" panose="02040502050505030304" pitchFamily="18" charset="0"/>
              </a:rPr>
              <a:t>.</a:t>
            </a:r>
            <a:endParaRPr lang="en-US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25642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1" y="6512356"/>
            <a:ext cx="67460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Supplementary Figure 6: Differential expressed genes </a:t>
            </a: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79A7DE47-F1B4-4AC7-8D83-37E99C9A479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3990" y="1142995"/>
            <a:ext cx="9144019" cy="45720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457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51</TotalTime>
  <Words>315</Words>
  <Application>Microsoft Office PowerPoint</Application>
  <PresentationFormat>Widescreen</PresentationFormat>
  <Paragraphs>8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Gothic A1 Regular</vt:lpstr>
      <vt:lpstr>맑은 고딕</vt:lpstr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thiyamoorthy</dc:creator>
  <cp:lastModifiedBy>Sathiyamoorthy</cp:lastModifiedBy>
  <cp:revision>75</cp:revision>
  <dcterms:created xsi:type="dcterms:W3CDTF">2021-04-08T00:31:30Z</dcterms:created>
  <dcterms:modified xsi:type="dcterms:W3CDTF">2021-10-05T05:00:15Z</dcterms:modified>
</cp:coreProperties>
</file>